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1.xml" ContentType="application/vnd.openxmlformats-officedocument.themeOverr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57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AA5B2B3-D3C1-4017-9724-9AB1C07733B2}" v="31" dt="2024-11-22T03:02:11.54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150" d="100"/>
          <a:sy n="150" d="100"/>
        </p:scale>
        <p:origin x="1512" y="-24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ao Song" userId="e6f0f2404ae517ad" providerId="LiveId" clId="{AAA5B2B3-D3C1-4017-9724-9AB1C07733B2}"/>
    <pc:docChg chg="undo custSel addSld modSld sldOrd">
      <pc:chgData name="Chao Song" userId="e6f0f2404ae517ad" providerId="LiveId" clId="{AAA5B2B3-D3C1-4017-9724-9AB1C07733B2}" dt="2024-11-22T03:03:37.730" v="748" actId="114"/>
      <pc:docMkLst>
        <pc:docMk/>
      </pc:docMkLst>
      <pc:sldChg chg="ord">
        <pc:chgData name="Chao Song" userId="e6f0f2404ae517ad" providerId="LiveId" clId="{AAA5B2B3-D3C1-4017-9724-9AB1C07733B2}" dt="2024-11-19T02:48:48.494" v="60"/>
        <pc:sldMkLst>
          <pc:docMk/>
          <pc:sldMk cId="3437913392" sldId="256"/>
        </pc:sldMkLst>
      </pc:sldChg>
      <pc:sldChg chg="modSp mod">
        <pc:chgData name="Chao Song" userId="e6f0f2404ae517ad" providerId="LiveId" clId="{AAA5B2B3-D3C1-4017-9724-9AB1C07733B2}" dt="2024-11-22T03:02:24.881" v="736" actId="114"/>
        <pc:sldMkLst>
          <pc:docMk/>
          <pc:sldMk cId="4221568519" sldId="257"/>
        </pc:sldMkLst>
        <pc:spChg chg="mod">
          <ac:chgData name="Chao Song" userId="e6f0f2404ae517ad" providerId="LiveId" clId="{AAA5B2B3-D3C1-4017-9724-9AB1C07733B2}" dt="2024-11-22T03:02:24.881" v="736" actId="114"/>
          <ac:spMkLst>
            <pc:docMk/>
            <pc:sldMk cId="4221568519" sldId="257"/>
            <ac:spMk id="5" creationId="{C615E4C5-CE6D-03B1-5841-6CB31165CE0F}"/>
          </ac:spMkLst>
        </pc:spChg>
      </pc:sldChg>
      <pc:sldChg chg="addSp delSp modSp new mod">
        <pc:chgData name="Chao Song" userId="e6f0f2404ae517ad" providerId="LiveId" clId="{AAA5B2B3-D3C1-4017-9724-9AB1C07733B2}" dt="2024-11-22T03:03:37.730" v="748" actId="114"/>
        <pc:sldMkLst>
          <pc:docMk/>
          <pc:sldMk cId="722221890" sldId="258"/>
        </pc:sldMkLst>
        <pc:spChg chg="add mod">
          <ac:chgData name="Chao Song" userId="e6f0f2404ae517ad" providerId="LiveId" clId="{AAA5B2B3-D3C1-4017-9724-9AB1C07733B2}" dt="2024-11-22T03:03:37.730" v="748" actId="114"/>
          <ac:spMkLst>
            <pc:docMk/>
            <pc:sldMk cId="722221890" sldId="258"/>
            <ac:spMk id="2" creationId="{7C89D3CD-52FE-50BD-4CC7-3AD15C470FDF}"/>
          </ac:spMkLst>
        </pc:spChg>
        <pc:spChg chg="del">
          <ac:chgData name="Chao Song" userId="e6f0f2404ae517ad" providerId="LiveId" clId="{AAA5B2B3-D3C1-4017-9724-9AB1C07733B2}" dt="2024-11-14T14:42:57.297" v="1" actId="478"/>
          <ac:spMkLst>
            <pc:docMk/>
            <pc:sldMk cId="722221890" sldId="258"/>
            <ac:spMk id="2" creationId="{B5FD5F28-D273-8EAB-3A9A-00DCA823F177}"/>
          </ac:spMkLst>
        </pc:spChg>
        <pc:spChg chg="del">
          <ac:chgData name="Chao Song" userId="e6f0f2404ae517ad" providerId="LiveId" clId="{AAA5B2B3-D3C1-4017-9724-9AB1C07733B2}" dt="2024-11-14T14:42:57.297" v="1" actId="478"/>
          <ac:spMkLst>
            <pc:docMk/>
            <pc:sldMk cId="722221890" sldId="258"/>
            <ac:spMk id="3" creationId="{FDD1BDA0-0139-18FF-080E-0E18F54D155E}"/>
          </ac:spMkLst>
        </pc:spChg>
        <pc:spChg chg="mod topLvl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9" creationId="{3DEB3958-2ADF-AB57-F700-522AAD551733}"/>
          </ac:spMkLst>
        </pc:spChg>
        <pc:spChg chg="mod topLvl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10" creationId="{2759BE3F-E3DC-B897-7A28-4CA27D81A556}"/>
          </ac:spMkLst>
        </pc:spChg>
        <pc:spChg chg="mod topLvl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11" creationId="{408417D4-899D-0C1E-F157-A42DEE17C8BC}"/>
          </ac:spMkLst>
        </pc:spChg>
        <pc:spChg chg="mod topLvl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12" creationId="{DB2BD96F-22BE-0E41-2039-4AF2D5A142CA}"/>
          </ac:spMkLst>
        </pc:spChg>
        <pc:spChg chg="mod topLvl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13" creationId="{7BE4A0F7-56D0-BE9D-C415-D8B6D0D95494}"/>
          </ac:spMkLst>
        </pc:spChg>
        <pc:spChg chg="mod topLvl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14" creationId="{ADC11A23-4264-2A14-70A7-062C5853B9F3}"/>
          </ac:spMkLst>
        </pc:spChg>
        <pc:spChg chg="mod topLvl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15" creationId="{DD75021C-0D8F-A23B-709C-F3684B42269B}"/>
          </ac:spMkLst>
        </pc:spChg>
        <pc:spChg chg="mod topLvl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16" creationId="{5A9811C7-780F-BB81-D3B5-71A3DA81D80A}"/>
          </ac:spMkLst>
        </pc:spChg>
        <pc:spChg chg="mod topLvl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17" creationId="{D321F092-753E-92F8-0566-DED66F20D80A}"/>
          </ac:spMkLst>
        </pc:spChg>
        <pc:spChg chg="mod topLvl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24" creationId="{59CC7791-8C03-1F82-7C87-47567913B9B4}"/>
          </ac:spMkLst>
        </pc:spChg>
        <pc:spChg chg="mod topLvl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25" creationId="{4B0E3A53-99AC-CBE4-B2DC-18582A0B419A}"/>
          </ac:spMkLst>
        </pc:spChg>
        <pc:spChg chg="mod topLvl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26" creationId="{9F4485AE-9933-5ED7-C810-7A7B21FDE722}"/>
          </ac:spMkLst>
        </pc:spChg>
        <pc:spChg chg="mod topLvl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27" creationId="{185E7842-1F9E-2CF5-0714-29C526087680}"/>
          </ac:spMkLst>
        </pc:spChg>
        <pc:spChg chg="mod topLvl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28" creationId="{C641FD77-27E8-F6FA-BC89-7BE3A86DF239}"/>
          </ac:spMkLst>
        </pc:spChg>
        <pc:spChg chg="mod topLvl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29" creationId="{274674F4-DD79-8205-59E8-1D5BD39DFD5F}"/>
          </ac:spMkLst>
        </pc:spChg>
        <pc:spChg chg="mod topLvl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30" creationId="{5D9BC2A8-04F8-14C3-6FD8-24475AF10ACD}"/>
          </ac:spMkLst>
        </pc:spChg>
        <pc:spChg chg="mod topLvl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31" creationId="{09DF51BA-2DAD-D9AC-A302-FAD57900FF7A}"/>
          </ac:spMkLst>
        </pc:spChg>
        <pc:spChg chg="mod topLvl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32" creationId="{692F4714-662B-7C76-FC9B-74BD68485F9C}"/>
          </ac:spMkLst>
        </pc:spChg>
        <pc:spChg chg="mod topLvl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34" creationId="{90AD77C3-00FF-18F4-4BE7-4D932B14F11A}"/>
          </ac:spMkLst>
        </pc:spChg>
        <pc:spChg chg="mod topLvl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38" creationId="{E83016CF-5DB1-8571-313A-53EB088EE08B}"/>
          </ac:spMkLst>
        </pc:spChg>
        <pc:spChg chg="mod topLvl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40" creationId="{AC8DB28B-B631-B3B3-CA28-B3453834AC04}"/>
          </ac:spMkLst>
        </pc:spChg>
        <pc:spChg chg="mod topLvl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41" creationId="{BACD6EC1-E93C-0C0D-C974-B77890CCC8A0}"/>
          </ac:spMkLst>
        </pc:spChg>
        <pc:spChg chg="mod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42" creationId="{639B239D-30B0-846D-86B8-984DEC291B50}"/>
          </ac:spMkLst>
        </pc:spChg>
        <pc:spChg chg="mod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43" creationId="{8904AC13-E521-CA45-4FF9-2BA8A4A2B648}"/>
          </ac:spMkLst>
        </pc:spChg>
        <pc:spChg chg="mod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44" creationId="{91F15DE1-1BB2-FB5B-C586-06863DF4C190}"/>
          </ac:spMkLst>
        </pc:spChg>
        <pc:spChg chg="mod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45" creationId="{1FC08D63-4019-F0DB-C3C4-17B8A0507729}"/>
          </ac:spMkLst>
        </pc:spChg>
        <pc:spChg chg="mod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46" creationId="{031A2860-35F8-1FAD-860F-88C17026CB7F}"/>
          </ac:spMkLst>
        </pc:spChg>
        <pc:spChg chg="mod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47" creationId="{4DE2C86A-AA2D-303E-F039-4336BE73B267}"/>
          </ac:spMkLst>
        </pc:spChg>
        <pc:spChg chg="mod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48" creationId="{2E12EC44-4FB9-2A95-4EEC-60D3AF4BB820}"/>
          </ac:spMkLst>
        </pc:spChg>
        <pc:spChg chg="mod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49" creationId="{D854D46C-B324-E645-9A00-3DD40F344919}"/>
          </ac:spMkLst>
        </pc:spChg>
        <pc:spChg chg="mod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50" creationId="{54E3C9C0-867C-CF8B-F90E-6CE3BF99C86C}"/>
          </ac:spMkLst>
        </pc:spChg>
        <pc:spChg chg="mod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51" creationId="{8F0D921E-7CF0-DA2A-1ACC-076C86635B35}"/>
          </ac:spMkLst>
        </pc:spChg>
        <pc:spChg chg="mod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52" creationId="{A721400D-464B-0468-65F5-3F63BF6C29E3}"/>
          </ac:spMkLst>
        </pc:spChg>
        <pc:spChg chg="mod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53" creationId="{C5544E74-FCAA-0D08-FADC-1ACE77FE88DB}"/>
          </ac:spMkLst>
        </pc:spChg>
        <pc:spChg chg="mod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54" creationId="{E78948B5-1423-B601-2A1B-A7D47B154996}"/>
          </ac:spMkLst>
        </pc:spChg>
        <pc:spChg chg="mod">
          <ac:chgData name="Chao Song" userId="e6f0f2404ae517ad" providerId="LiveId" clId="{AAA5B2B3-D3C1-4017-9724-9AB1C07733B2}" dt="2024-11-19T09:52:20.401" v="410" actId="1076"/>
          <ac:spMkLst>
            <pc:docMk/>
            <pc:sldMk cId="722221890" sldId="258"/>
            <ac:spMk id="55" creationId="{A050E0FB-1DF6-90C3-776D-9935DBE10343}"/>
          </ac:spMkLst>
        </pc:spChg>
        <pc:spChg chg="add del mod">
          <ac:chgData name="Chao Song" userId="e6f0f2404ae517ad" providerId="LiveId" clId="{AAA5B2B3-D3C1-4017-9724-9AB1C07733B2}" dt="2024-11-14T14:49:25.493" v="13" actId="478"/>
          <ac:spMkLst>
            <pc:docMk/>
            <pc:sldMk cId="722221890" sldId="258"/>
            <ac:spMk id="56" creationId="{6F653691-5ABC-26D0-8B38-B5818501321A}"/>
          </ac:spMkLst>
        </pc:spChg>
        <pc:spChg chg="add mod">
          <ac:chgData name="Chao Song" userId="e6f0f2404ae517ad" providerId="LiveId" clId="{AAA5B2B3-D3C1-4017-9724-9AB1C07733B2}" dt="2024-11-19T09:05:37.812" v="100"/>
          <ac:spMkLst>
            <pc:docMk/>
            <pc:sldMk cId="722221890" sldId="258"/>
            <ac:spMk id="56" creationId="{DADD3885-613C-25F3-3E3A-82F1BE34A4C6}"/>
          </ac:spMkLst>
        </pc:spChg>
        <pc:spChg chg="add del mod">
          <ac:chgData name="Chao Song" userId="e6f0f2404ae517ad" providerId="LiveId" clId="{AAA5B2B3-D3C1-4017-9724-9AB1C07733B2}" dt="2024-11-19T09:51:55.980" v="404" actId="478"/>
          <ac:spMkLst>
            <pc:docMk/>
            <pc:sldMk cId="722221890" sldId="258"/>
            <ac:spMk id="58" creationId="{063B2516-AF47-A89C-1DC3-58414FBB0C27}"/>
          </ac:spMkLst>
        </pc:spChg>
        <pc:spChg chg="add del mod">
          <ac:chgData name="Chao Song" userId="e6f0f2404ae517ad" providerId="LiveId" clId="{AAA5B2B3-D3C1-4017-9724-9AB1C07733B2}" dt="2024-11-19T02:49:09.235" v="63" actId="478"/>
          <ac:spMkLst>
            <pc:docMk/>
            <pc:sldMk cId="722221890" sldId="258"/>
            <ac:spMk id="59" creationId="{E6172B15-44B8-F9CC-B778-09A85DDAA42E}"/>
          </ac:spMkLst>
        </pc:spChg>
        <pc:grpChg chg="add mod">
          <ac:chgData name="Chao Song" userId="e6f0f2404ae517ad" providerId="LiveId" clId="{AAA5B2B3-D3C1-4017-9724-9AB1C07733B2}" dt="2024-11-19T09:52:20.401" v="410" actId="1076"/>
          <ac:grpSpMkLst>
            <pc:docMk/>
            <pc:sldMk cId="722221890" sldId="258"/>
            <ac:grpSpMk id="3" creationId="{0C1FB9D8-EEAD-BD7E-EB29-B6AC64FBEB8A}"/>
          </ac:grpSpMkLst>
        </pc:grpChg>
        <pc:grpChg chg="add del mod">
          <ac:chgData name="Chao Song" userId="e6f0f2404ae517ad" providerId="LiveId" clId="{AAA5B2B3-D3C1-4017-9724-9AB1C07733B2}" dt="2024-11-19T02:50:05.604" v="91" actId="165"/>
          <ac:grpSpMkLst>
            <pc:docMk/>
            <pc:sldMk cId="722221890" sldId="258"/>
            <ac:grpSpMk id="4" creationId="{B1574DFE-D083-8133-5263-9B01F233CE7A}"/>
          </ac:grpSpMkLst>
        </pc:grpChg>
        <pc:grpChg chg="mod topLvl">
          <ac:chgData name="Chao Song" userId="e6f0f2404ae517ad" providerId="LiveId" clId="{AAA5B2B3-D3C1-4017-9724-9AB1C07733B2}" dt="2024-11-19T09:52:20.401" v="410" actId="1076"/>
          <ac:grpSpMkLst>
            <pc:docMk/>
            <pc:sldMk cId="722221890" sldId="258"/>
            <ac:grpSpMk id="39" creationId="{AFCB13B6-952C-3B3F-FC17-468C4345DF4D}"/>
          </ac:grpSpMkLst>
        </pc:grpChg>
        <pc:picChg chg="mod topLvl">
          <ac:chgData name="Chao Song" userId="e6f0f2404ae517ad" providerId="LiveId" clId="{AAA5B2B3-D3C1-4017-9724-9AB1C07733B2}" dt="2024-11-19T09:52:20.401" v="410" actId="1076"/>
          <ac:picMkLst>
            <pc:docMk/>
            <pc:sldMk cId="722221890" sldId="258"/>
            <ac:picMk id="5" creationId="{077130E8-72BB-E122-78CE-087DEBD21339}"/>
          </ac:picMkLst>
        </pc:picChg>
        <pc:picChg chg="mod topLvl">
          <ac:chgData name="Chao Song" userId="e6f0f2404ae517ad" providerId="LiveId" clId="{AAA5B2B3-D3C1-4017-9724-9AB1C07733B2}" dt="2024-11-19T09:52:20.401" v="410" actId="1076"/>
          <ac:picMkLst>
            <pc:docMk/>
            <pc:sldMk cId="722221890" sldId="258"/>
            <ac:picMk id="6" creationId="{E3A43444-B7AB-557E-9AA9-28F14F9E9189}"/>
          </ac:picMkLst>
        </pc:picChg>
        <pc:picChg chg="mod topLvl">
          <ac:chgData name="Chao Song" userId="e6f0f2404ae517ad" providerId="LiveId" clId="{AAA5B2B3-D3C1-4017-9724-9AB1C07733B2}" dt="2024-11-19T09:52:20.401" v="410" actId="1076"/>
          <ac:picMkLst>
            <pc:docMk/>
            <pc:sldMk cId="722221890" sldId="258"/>
            <ac:picMk id="7" creationId="{B5CA0761-E62B-F131-115D-B8A6D7F2DDBC}"/>
          </ac:picMkLst>
        </pc:picChg>
        <pc:picChg chg="mod topLvl">
          <ac:chgData name="Chao Song" userId="e6f0f2404ae517ad" providerId="LiveId" clId="{AAA5B2B3-D3C1-4017-9724-9AB1C07733B2}" dt="2024-11-19T09:52:20.401" v="410" actId="1076"/>
          <ac:picMkLst>
            <pc:docMk/>
            <pc:sldMk cId="722221890" sldId="258"/>
            <ac:picMk id="33" creationId="{2B709189-7397-B23F-A7E0-698D226E5256}"/>
          </ac:picMkLst>
        </pc:picChg>
        <pc:cxnChg chg="mod topLvl">
          <ac:chgData name="Chao Song" userId="e6f0f2404ae517ad" providerId="LiveId" clId="{AAA5B2B3-D3C1-4017-9724-9AB1C07733B2}" dt="2024-11-19T09:52:20.401" v="410" actId="1076"/>
          <ac:cxnSpMkLst>
            <pc:docMk/>
            <pc:sldMk cId="722221890" sldId="258"/>
            <ac:cxnSpMk id="8" creationId="{631D831A-525A-8D10-2DA3-18AF15330E11}"/>
          </ac:cxnSpMkLst>
        </pc:cxnChg>
        <pc:cxnChg chg="mod topLvl">
          <ac:chgData name="Chao Song" userId="e6f0f2404ae517ad" providerId="LiveId" clId="{AAA5B2B3-D3C1-4017-9724-9AB1C07733B2}" dt="2024-11-19T09:52:20.401" v="410" actId="1076"/>
          <ac:cxnSpMkLst>
            <pc:docMk/>
            <pc:sldMk cId="722221890" sldId="258"/>
            <ac:cxnSpMk id="18" creationId="{2F3CE90A-07D5-AD4D-1B64-1726F44578E2}"/>
          </ac:cxnSpMkLst>
        </pc:cxnChg>
        <pc:cxnChg chg="mod topLvl">
          <ac:chgData name="Chao Song" userId="e6f0f2404ae517ad" providerId="LiveId" clId="{AAA5B2B3-D3C1-4017-9724-9AB1C07733B2}" dt="2024-11-19T09:52:20.401" v="410" actId="1076"/>
          <ac:cxnSpMkLst>
            <pc:docMk/>
            <pc:sldMk cId="722221890" sldId="258"/>
            <ac:cxnSpMk id="19" creationId="{35A072F3-E421-5E04-9D11-CAB4FBB4D25B}"/>
          </ac:cxnSpMkLst>
        </pc:cxnChg>
        <pc:cxnChg chg="mod topLvl">
          <ac:chgData name="Chao Song" userId="e6f0f2404ae517ad" providerId="LiveId" clId="{AAA5B2B3-D3C1-4017-9724-9AB1C07733B2}" dt="2024-11-19T09:52:20.401" v="410" actId="1076"/>
          <ac:cxnSpMkLst>
            <pc:docMk/>
            <pc:sldMk cId="722221890" sldId="258"/>
            <ac:cxnSpMk id="20" creationId="{889BC767-87C1-B762-DEB2-12AF3257E5D9}"/>
          </ac:cxnSpMkLst>
        </pc:cxnChg>
        <pc:cxnChg chg="mod topLvl">
          <ac:chgData name="Chao Song" userId="e6f0f2404ae517ad" providerId="LiveId" clId="{AAA5B2B3-D3C1-4017-9724-9AB1C07733B2}" dt="2024-11-19T09:52:20.401" v="410" actId="1076"/>
          <ac:cxnSpMkLst>
            <pc:docMk/>
            <pc:sldMk cId="722221890" sldId="258"/>
            <ac:cxnSpMk id="21" creationId="{F688F053-FA32-045E-24B9-1B0F38F925D1}"/>
          </ac:cxnSpMkLst>
        </pc:cxnChg>
        <pc:cxnChg chg="mod topLvl">
          <ac:chgData name="Chao Song" userId="e6f0f2404ae517ad" providerId="LiveId" clId="{AAA5B2B3-D3C1-4017-9724-9AB1C07733B2}" dt="2024-11-19T09:52:20.401" v="410" actId="1076"/>
          <ac:cxnSpMkLst>
            <pc:docMk/>
            <pc:sldMk cId="722221890" sldId="258"/>
            <ac:cxnSpMk id="22" creationId="{D78DE80F-85F4-2495-4018-CB0B2E26763E}"/>
          </ac:cxnSpMkLst>
        </pc:cxnChg>
        <pc:cxnChg chg="mod topLvl">
          <ac:chgData name="Chao Song" userId="e6f0f2404ae517ad" providerId="LiveId" clId="{AAA5B2B3-D3C1-4017-9724-9AB1C07733B2}" dt="2024-11-19T09:52:20.401" v="410" actId="1076"/>
          <ac:cxnSpMkLst>
            <pc:docMk/>
            <pc:sldMk cId="722221890" sldId="258"/>
            <ac:cxnSpMk id="23" creationId="{BA97759A-1635-3046-107B-5F547ECE4208}"/>
          </ac:cxnSpMkLst>
        </pc:cxnChg>
        <pc:cxnChg chg="mod topLvl">
          <ac:chgData name="Chao Song" userId="e6f0f2404ae517ad" providerId="LiveId" clId="{AAA5B2B3-D3C1-4017-9724-9AB1C07733B2}" dt="2024-11-19T09:52:20.401" v="410" actId="1076"/>
          <ac:cxnSpMkLst>
            <pc:docMk/>
            <pc:sldMk cId="722221890" sldId="258"/>
            <ac:cxnSpMk id="35" creationId="{3932E031-7D48-890B-204B-0BC4B89DF296}"/>
          </ac:cxnSpMkLst>
        </pc:cxnChg>
        <pc:cxnChg chg="mod topLvl">
          <ac:chgData name="Chao Song" userId="e6f0f2404ae517ad" providerId="LiveId" clId="{AAA5B2B3-D3C1-4017-9724-9AB1C07733B2}" dt="2024-11-19T09:52:20.401" v="410" actId="1076"/>
          <ac:cxnSpMkLst>
            <pc:docMk/>
            <pc:sldMk cId="722221890" sldId="258"/>
            <ac:cxnSpMk id="36" creationId="{FB10B4B7-6747-03CE-D362-761A87F9667B}"/>
          </ac:cxnSpMkLst>
        </pc:cxnChg>
        <pc:cxnChg chg="mod topLvl">
          <ac:chgData name="Chao Song" userId="e6f0f2404ae517ad" providerId="LiveId" clId="{AAA5B2B3-D3C1-4017-9724-9AB1C07733B2}" dt="2024-11-19T09:52:20.401" v="410" actId="1076"/>
          <ac:cxnSpMkLst>
            <pc:docMk/>
            <pc:sldMk cId="722221890" sldId="258"/>
            <ac:cxnSpMk id="37" creationId="{1CD8D9D4-1F32-A713-8FCE-3D35528335A0}"/>
          </ac:cxnSpMkLst>
        </pc:cxnChg>
      </pc:sldChg>
    </pc:docChg>
  </pc:docChgLst>
  <pc:docChgLst>
    <pc:chgData name="Chao Song" userId="e6f0f2404ae517ad" providerId="LiveId" clId="{C1486E1F-191E-4F8A-8180-A4400F715D3C}"/>
    <pc:docChg chg="modSld">
      <pc:chgData name="Chao Song" userId="e6f0f2404ae517ad" providerId="LiveId" clId="{C1486E1F-191E-4F8A-8180-A4400F715D3C}" dt="2024-07-24T08:25:54.904" v="0" actId="113"/>
      <pc:docMkLst>
        <pc:docMk/>
      </pc:docMkLst>
      <pc:sldChg chg="modSp mod">
        <pc:chgData name="Chao Song" userId="e6f0f2404ae517ad" providerId="LiveId" clId="{C1486E1F-191E-4F8A-8180-A4400F715D3C}" dt="2024-07-24T08:25:54.904" v="0" actId="113"/>
        <pc:sldMkLst>
          <pc:docMk/>
          <pc:sldMk cId="3437913392" sldId="256"/>
        </pc:sldMkLst>
        <pc:spChg chg="mod">
          <ac:chgData name="Chao Song" userId="e6f0f2404ae517ad" providerId="LiveId" clId="{C1486E1F-191E-4F8A-8180-A4400F715D3C}" dt="2024-07-24T08:25:54.904" v="0" actId="113"/>
          <ac:spMkLst>
            <pc:docMk/>
            <pc:sldMk cId="3437913392" sldId="256"/>
            <ac:spMk id="4" creationId="{743CE3B8-96C5-5281-D96E-657CD3C59ECB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e6f0f2404ae517ad/1%20Postdoc/1%20&#21512;&#20316;&#39033;&#30446;/&#23004;&#33655;&#33457;/New%20Analysis/Original%20data%20update/3%20Meta/7%20&#32452;&#25104;&#27604;&#20363;/2%20&#32452;&#25104;&#27604;&#20363;_8%20cultivar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e6f0f2404ae517ad/1%20Postdoc/1%20&#21512;&#20316;&#39033;&#30446;/&#23004;&#33655;&#33457;/New%20Analysis/Original%20data%20update/3%20Meta/7%20&#32452;&#25104;&#27604;&#20363;/4%20stages/5%20&#32452;&#25104;&#27604;&#20363;_stage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../embeddings/oleObject1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814254315636856"/>
          <c:y val="0.17031054084273906"/>
          <c:w val="0.80130189282302589"/>
          <c:h val="0.75756774720255415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Bar plot'!$K$8</c:f>
              <c:strCache>
                <c:ptCount val="1"/>
                <c:pt idx="0">
                  <c:v>Other</c:v>
                </c:pt>
              </c:strCache>
            </c:strRef>
          </c:tx>
          <c:spPr>
            <a:solidFill>
              <a:srgbClr val="7F7F7F"/>
            </a:solidFill>
            <a:ln>
              <a:noFill/>
            </a:ln>
            <a:effectLst/>
          </c:spPr>
          <c:invertIfNegative val="0"/>
          <c:cat>
            <c:strRef>
              <c:f>'Bar plot'!$L$1:$S$1</c:f>
              <c:strCache>
                <c:ptCount val="8"/>
                <c:pt idx="0">
                  <c:v>YRY</c:v>
                </c:pt>
                <c:pt idx="1">
                  <c:v>QMF</c:v>
                </c:pt>
                <c:pt idx="2">
                  <c:v>YZH</c:v>
                </c:pt>
                <c:pt idx="3">
                  <c:v>JL</c:v>
                </c:pt>
                <c:pt idx="4">
                  <c:v>BXGZ</c:v>
                </c:pt>
                <c:pt idx="5">
                  <c:v>HY</c:v>
                </c:pt>
                <c:pt idx="6">
                  <c:v>LM</c:v>
                </c:pt>
                <c:pt idx="7">
                  <c:v>YIKI</c:v>
                </c:pt>
              </c:strCache>
            </c:strRef>
          </c:cat>
          <c:val>
            <c:numRef>
              <c:f>'Bar plot'!$L$8:$S$8</c:f>
              <c:numCache>
                <c:formatCode>0.00E+00</c:formatCode>
                <c:ptCount val="8"/>
                <c:pt idx="0">
                  <c:v>125840601.59920001</c:v>
                </c:pt>
                <c:pt idx="1">
                  <c:v>126841598.7098</c:v>
                </c:pt>
                <c:pt idx="2">
                  <c:v>113565962.78729999</c:v>
                </c:pt>
                <c:pt idx="3">
                  <c:v>103756485.61860001</c:v>
                </c:pt>
                <c:pt idx="4">
                  <c:v>106202264.14910001</c:v>
                </c:pt>
                <c:pt idx="5">
                  <c:v>74653399.055290014</c:v>
                </c:pt>
                <c:pt idx="6">
                  <c:v>76181428.230399996</c:v>
                </c:pt>
                <c:pt idx="7">
                  <c:v>60852427.8968799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4D6-4734-BD1C-18CAE090181D}"/>
            </c:ext>
          </c:extLst>
        </c:ser>
        <c:ser>
          <c:idx val="9"/>
          <c:order val="1"/>
          <c:tx>
            <c:strRef>
              <c:f>'Bar plot'!$K$2</c:f>
              <c:strCache>
                <c:ptCount val="1"/>
                <c:pt idx="0">
                  <c:v>Alcohol</c:v>
                </c:pt>
              </c:strCache>
            </c:strRef>
          </c:tx>
          <c:spPr>
            <a:solidFill>
              <a:srgbClr val="6A994E"/>
            </a:solidFill>
            <a:ln>
              <a:noFill/>
            </a:ln>
            <a:effectLst/>
          </c:spPr>
          <c:invertIfNegative val="0"/>
          <c:cat>
            <c:strRef>
              <c:f>'Bar plot'!$L$1:$S$1</c:f>
              <c:strCache>
                <c:ptCount val="8"/>
                <c:pt idx="0">
                  <c:v>YRY</c:v>
                </c:pt>
                <c:pt idx="1">
                  <c:v>QMF</c:v>
                </c:pt>
                <c:pt idx="2">
                  <c:v>YZH</c:v>
                </c:pt>
                <c:pt idx="3">
                  <c:v>JL</c:v>
                </c:pt>
                <c:pt idx="4">
                  <c:v>BXGZ</c:v>
                </c:pt>
                <c:pt idx="5">
                  <c:v>HY</c:v>
                </c:pt>
                <c:pt idx="6">
                  <c:v>LM</c:v>
                </c:pt>
                <c:pt idx="7">
                  <c:v>YIKI</c:v>
                </c:pt>
              </c:strCache>
            </c:strRef>
          </c:cat>
          <c:val>
            <c:numRef>
              <c:f>'Bar plot'!$L$2:$S$2</c:f>
              <c:numCache>
                <c:formatCode>0.00E+00</c:formatCode>
                <c:ptCount val="8"/>
                <c:pt idx="0">
                  <c:v>78503317.5</c:v>
                </c:pt>
                <c:pt idx="1">
                  <c:v>41699730.280000001</c:v>
                </c:pt>
                <c:pt idx="2">
                  <c:v>44815174.093999997</c:v>
                </c:pt>
                <c:pt idx="3">
                  <c:v>39855463.880000003</c:v>
                </c:pt>
                <c:pt idx="4">
                  <c:v>32537555.219999999</c:v>
                </c:pt>
                <c:pt idx="5">
                  <c:v>43540972.215999998</c:v>
                </c:pt>
                <c:pt idx="6">
                  <c:v>32860150.572999999</c:v>
                </c:pt>
                <c:pt idx="7">
                  <c:v>27649947.317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4D6-4734-BD1C-18CAE090181D}"/>
            </c:ext>
          </c:extLst>
        </c:ser>
        <c:ser>
          <c:idx val="10"/>
          <c:order val="2"/>
          <c:tx>
            <c:strRef>
              <c:f>'Bar plot'!$K$3</c:f>
              <c:strCache>
                <c:ptCount val="1"/>
                <c:pt idx="0">
                  <c:v>Ester</c:v>
                </c:pt>
              </c:strCache>
            </c:strRef>
          </c:tx>
          <c:spPr>
            <a:solidFill>
              <a:srgbClr val="B5E2FA"/>
            </a:solidFill>
            <a:ln>
              <a:noFill/>
            </a:ln>
            <a:effectLst/>
          </c:spPr>
          <c:invertIfNegative val="0"/>
          <c:cat>
            <c:strRef>
              <c:f>'Bar plot'!$L$1:$S$1</c:f>
              <c:strCache>
                <c:ptCount val="8"/>
                <c:pt idx="0">
                  <c:v>YRY</c:v>
                </c:pt>
                <c:pt idx="1">
                  <c:v>QMF</c:v>
                </c:pt>
                <c:pt idx="2">
                  <c:v>YZH</c:v>
                </c:pt>
                <c:pt idx="3">
                  <c:v>JL</c:v>
                </c:pt>
                <c:pt idx="4">
                  <c:v>BXGZ</c:v>
                </c:pt>
                <c:pt idx="5">
                  <c:v>HY</c:v>
                </c:pt>
                <c:pt idx="6">
                  <c:v>LM</c:v>
                </c:pt>
                <c:pt idx="7">
                  <c:v>YIKI</c:v>
                </c:pt>
              </c:strCache>
            </c:strRef>
          </c:cat>
          <c:val>
            <c:numRef>
              <c:f>'Bar plot'!$L$3:$S$3</c:f>
              <c:numCache>
                <c:formatCode>0.00E+00</c:formatCode>
                <c:ptCount val="8"/>
                <c:pt idx="0">
                  <c:v>104834208.54000001</c:v>
                </c:pt>
                <c:pt idx="1">
                  <c:v>74303348.397</c:v>
                </c:pt>
                <c:pt idx="2">
                  <c:v>90448480.388999999</c:v>
                </c:pt>
                <c:pt idx="3">
                  <c:v>75513066.767000005</c:v>
                </c:pt>
                <c:pt idx="4">
                  <c:v>80384739.111000001</c:v>
                </c:pt>
                <c:pt idx="5">
                  <c:v>54726213.939999998</c:v>
                </c:pt>
                <c:pt idx="6">
                  <c:v>54362497.682999998</c:v>
                </c:pt>
                <c:pt idx="7">
                  <c:v>38847239.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4D6-4734-BD1C-18CAE090181D}"/>
            </c:ext>
          </c:extLst>
        </c:ser>
        <c:ser>
          <c:idx val="11"/>
          <c:order val="3"/>
          <c:tx>
            <c:strRef>
              <c:f>'Bar plot'!$K$4</c:f>
              <c:strCache>
                <c:ptCount val="1"/>
                <c:pt idx="0">
                  <c:v>Heterocyclic compound</c:v>
                </c:pt>
              </c:strCache>
            </c:strRef>
          </c:tx>
          <c:spPr>
            <a:solidFill>
              <a:srgbClr val="83C5BE"/>
            </a:solidFill>
            <a:ln>
              <a:noFill/>
            </a:ln>
            <a:effectLst/>
          </c:spPr>
          <c:invertIfNegative val="0"/>
          <c:cat>
            <c:strRef>
              <c:f>'Bar plot'!$L$1:$S$1</c:f>
              <c:strCache>
                <c:ptCount val="8"/>
                <c:pt idx="0">
                  <c:v>YRY</c:v>
                </c:pt>
                <c:pt idx="1">
                  <c:v>QMF</c:v>
                </c:pt>
                <c:pt idx="2">
                  <c:v>YZH</c:v>
                </c:pt>
                <c:pt idx="3">
                  <c:v>JL</c:v>
                </c:pt>
                <c:pt idx="4">
                  <c:v>BXGZ</c:v>
                </c:pt>
                <c:pt idx="5">
                  <c:v>HY</c:v>
                </c:pt>
                <c:pt idx="6">
                  <c:v>LM</c:v>
                </c:pt>
                <c:pt idx="7">
                  <c:v>YIKI</c:v>
                </c:pt>
              </c:strCache>
            </c:strRef>
          </c:cat>
          <c:val>
            <c:numRef>
              <c:f>'Bar plot'!$L$4:$S$4</c:f>
              <c:numCache>
                <c:formatCode>0.00E+00</c:formatCode>
                <c:ptCount val="8"/>
                <c:pt idx="0">
                  <c:v>151069949.63999999</c:v>
                </c:pt>
                <c:pt idx="1">
                  <c:v>100639616.03</c:v>
                </c:pt>
                <c:pt idx="2">
                  <c:v>89263417.474000007</c:v>
                </c:pt>
                <c:pt idx="3">
                  <c:v>75582432.452999994</c:v>
                </c:pt>
                <c:pt idx="4">
                  <c:v>75199052.760000005</c:v>
                </c:pt>
                <c:pt idx="5">
                  <c:v>68756873.151999995</c:v>
                </c:pt>
                <c:pt idx="6">
                  <c:v>71149298.599000007</c:v>
                </c:pt>
                <c:pt idx="7">
                  <c:v>63621281.515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4D6-4734-BD1C-18CAE090181D}"/>
            </c:ext>
          </c:extLst>
        </c:ser>
        <c:ser>
          <c:idx val="12"/>
          <c:order val="4"/>
          <c:tx>
            <c:strRef>
              <c:f>'Bar plot'!$K$5</c:f>
              <c:strCache>
                <c:ptCount val="1"/>
                <c:pt idx="0">
                  <c:v>Hydrocarbons</c:v>
                </c:pt>
              </c:strCache>
            </c:strRef>
          </c:tx>
          <c:spPr>
            <a:solidFill>
              <a:srgbClr val="68B5C9"/>
            </a:solidFill>
            <a:ln>
              <a:noFill/>
            </a:ln>
            <a:effectLst/>
          </c:spPr>
          <c:invertIfNegative val="0"/>
          <c:cat>
            <c:strRef>
              <c:f>'Bar plot'!$L$1:$S$1</c:f>
              <c:strCache>
                <c:ptCount val="8"/>
                <c:pt idx="0">
                  <c:v>YRY</c:v>
                </c:pt>
                <c:pt idx="1">
                  <c:v>QMF</c:v>
                </c:pt>
                <c:pt idx="2">
                  <c:v>YZH</c:v>
                </c:pt>
                <c:pt idx="3">
                  <c:v>JL</c:v>
                </c:pt>
                <c:pt idx="4">
                  <c:v>BXGZ</c:v>
                </c:pt>
                <c:pt idx="5">
                  <c:v>HY</c:v>
                </c:pt>
                <c:pt idx="6">
                  <c:v>LM</c:v>
                </c:pt>
                <c:pt idx="7">
                  <c:v>YIKI</c:v>
                </c:pt>
              </c:strCache>
            </c:strRef>
          </c:cat>
          <c:val>
            <c:numRef>
              <c:f>'Bar plot'!$L$5:$S$5</c:f>
              <c:numCache>
                <c:formatCode>0.00E+00</c:formatCode>
                <c:ptCount val="8"/>
                <c:pt idx="0">
                  <c:v>151235300.50999999</c:v>
                </c:pt>
                <c:pt idx="1">
                  <c:v>46658925.723999999</c:v>
                </c:pt>
                <c:pt idx="2">
                  <c:v>15181644.492000001</c:v>
                </c:pt>
                <c:pt idx="3">
                  <c:v>14195108.984999999</c:v>
                </c:pt>
                <c:pt idx="4">
                  <c:v>20791705.145</c:v>
                </c:pt>
                <c:pt idx="5">
                  <c:v>21651517.934</c:v>
                </c:pt>
                <c:pt idx="6">
                  <c:v>23205709.853999998</c:v>
                </c:pt>
                <c:pt idx="7">
                  <c:v>52771856.436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4D6-4734-BD1C-18CAE090181D}"/>
            </c:ext>
          </c:extLst>
        </c:ser>
        <c:ser>
          <c:idx val="13"/>
          <c:order val="5"/>
          <c:tx>
            <c:strRef>
              <c:f>'Bar plot'!$K$6</c:f>
              <c:strCache>
                <c:ptCount val="1"/>
                <c:pt idx="0">
                  <c:v>Ketone</c:v>
                </c:pt>
              </c:strCache>
            </c:strRef>
          </c:tx>
          <c:spPr>
            <a:solidFill>
              <a:srgbClr val="EDDEA4"/>
            </a:solidFill>
            <a:ln>
              <a:noFill/>
            </a:ln>
            <a:effectLst/>
          </c:spPr>
          <c:invertIfNegative val="0"/>
          <c:cat>
            <c:strRef>
              <c:f>'Bar plot'!$L$1:$S$1</c:f>
              <c:strCache>
                <c:ptCount val="8"/>
                <c:pt idx="0">
                  <c:v>YRY</c:v>
                </c:pt>
                <c:pt idx="1">
                  <c:v>QMF</c:v>
                </c:pt>
                <c:pt idx="2">
                  <c:v>YZH</c:v>
                </c:pt>
                <c:pt idx="3">
                  <c:v>JL</c:v>
                </c:pt>
                <c:pt idx="4">
                  <c:v>BXGZ</c:v>
                </c:pt>
                <c:pt idx="5">
                  <c:v>HY</c:v>
                </c:pt>
                <c:pt idx="6">
                  <c:v>LM</c:v>
                </c:pt>
                <c:pt idx="7">
                  <c:v>YIKI</c:v>
                </c:pt>
              </c:strCache>
            </c:strRef>
          </c:cat>
          <c:val>
            <c:numRef>
              <c:f>'Bar plot'!$L$6:$S$6</c:f>
              <c:numCache>
                <c:formatCode>0.00E+00</c:formatCode>
                <c:ptCount val="8"/>
                <c:pt idx="0">
                  <c:v>164634781.12</c:v>
                </c:pt>
                <c:pt idx="1">
                  <c:v>103136972.92</c:v>
                </c:pt>
                <c:pt idx="2">
                  <c:v>152673240.72</c:v>
                </c:pt>
                <c:pt idx="3">
                  <c:v>116643546.86</c:v>
                </c:pt>
                <c:pt idx="4">
                  <c:v>108448912.91</c:v>
                </c:pt>
                <c:pt idx="5">
                  <c:v>71727680.816</c:v>
                </c:pt>
                <c:pt idx="6">
                  <c:v>70652424.233999997</c:v>
                </c:pt>
                <c:pt idx="7">
                  <c:v>72842103.873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84D6-4734-BD1C-18CAE090181D}"/>
            </c:ext>
          </c:extLst>
        </c:ser>
        <c:ser>
          <c:idx val="14"/>
          <c:order val="6"/>
          <c:tx>
            <c:strRef>
              <c:f>'Bar plot'!$K$7</c:f>
              <c:strCache>
                <c:ptCount val="1"/>
                <c:pt idx="0">
                  <c:v>Terpenoids</c:v>
                </c:pt>
              </c:strCache>
            </c:strRef>
          </c:tx>
          <c:spPr>
            <a:solidFill>
              <a:srgbClr val="F7A072"/>
            </a:solidFill>
            <a:ln>
              <a:noFill/>
            </a:ln>
            <a:effectLst/>
          </c:spPr>
          <c:invertIfNegative val="0"/>
          <c:cat>
            <c:strRef>
              <c:f>'Bar plot'!$L$1:$S$1</c:f>
              <c:strCache>
                <c:ptCount val="8"/>
                <c:pt idx="0">
                  <c:v>YRY</c:v>
                </c:pt>
                <c:pt idx="1">
                  <c:v>QMF</c:v>
                </c:pt>
                <c:pt idx="2">
                  <c:v>YZH</c:v>
                </c:pt>
                <c:pt idx="3">
                  <c:v>JL</c:v>
                </c:pt>
                <c:pt idx="4">
                  <c:v>BXGZ</c:v>
                </c:pt>
                <c:pt idx="5">
                  <c:v>HY</c:v>
                </c:pt>
                <c:pt idx="6">
                  <c:v>LM</c:v>
                </c:pt>
                <c:pt idx="7">
                  <c:v>YIKI</c:v>
                </c:pt>
              </c:strCache>
            </c:strRef>
          </c:cat>
          <c:val>
            <c:numRef>
              <c:f>'Bar plot'!$L$7:$S$7</c:f>
              <c:numCache>
                <c:formatCode>0.00E+00</c:formatCode>
                <c:ptCount val="8"/>
                <c:pt idx="0">
                  <c:v>339956251.18000001</c:v>
                </c:pt>
                <c:pt idx="1">
                  <c:v>343333521.61000001</c:v>
                </c:pt>
                <c:pt idx="2">
                  <c:v>247753151.81999999</c:v>
                </c:pt>
                <c:pt idx="3">
                  <c:v>246233205.74000001</c:v>
                </c:pt>
                <c:pt idx="4">
                  <c:v>236543453.5</c:v>
                </c:pt>
                <c:pt idx="5">
                  <c:v>180947189.09</c:v>
                </c:pt>
                <c:pt idx="6">
                  <c:v>164819796.59</c:v>
                </c:pt>
                <c:pt idx="7">
                  <c:v>94093728.283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84D6-4734-BD1C-18CAE09018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824190159"/>
        <c:axId val="801297503"/>
      </c:barChart>
      <c:catAx>
        <c:axId val="824190159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one"/>
        <c:spPr>
          <a:noFill/>
          <a:ln w="15875" cap="sq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801297503"/>
        <c:crosses val="autoZero"/>
        <c:auto val="1"/>
        <c:lblAlgn val="ctr"/>
        <c:lblOffset val="100"/>
        <c:noMultiLvlLbl val="0"/>
      </c:catAx>
      <c:valAx>
        <c:axId val="80129750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ntensity</a:t>
                </a:r>
                <a:endParaRPr lang="zh-CN" alt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2.2000027606021912E-2"/>
              <c:y val="0.3126444246836845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0.0E+00" sourceLinked="0"/>
        <c:majorTickMark val="out"/>
        <c:minorTickMark val="none"/>
        <c:tickLblPos val="nextTo"/>
        <c:spPr>
          <a:noFill/>
          <a:ln w="15875" cap="sq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824190159"/>
        <c:crosses val="autoZero"/>
        <c:crossBetween val="between"/>
        <c:majorUnit val="3000000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421515435867341"/>
          <c:y val="0.10758184870707926"/>
          <c:w val="0.72839168482099736"/>
          <c:h val="0.8149934300788032"/>
        </c:manualLayout>
      </c:layout>
      <c:barChart>
        <c:barDir val="col"/>
        <c:grouping val="stacked"/>
        <c:varyColors val="0"/>
        <c:ser>
          <c:idx val="6"/>
          <c:order val="0"/>
          <c:tx>
            <c:strRef>
              <c:f>'Ratio_less class'!$A$8</c:f>
              <c:strCache>
                <c:ptCount val="1"/>
                <c:pt idx="0">
                  <c:v>Other</c:v>
                </c:pt>
              </c:strCache>
            </c:strRef>
          </c:tx>
          <c:spPr>
            <a:solidFill>
              <a:srgbClr val="7F7F7F"/>
            </a:solidFill>
            <a:ln>
              <a:noFill/>
            </a:ln>
            <a:effectLst/>
          </c:spPr>
          <c:invertIfNegative val="0"/>
          <c:cat>
            <c:strRef>
              <c:f>'Ratio_less class'!$B$1:$E$1</c:f>
              <c:strCache>
                <c:ptCount val="4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</c:strCache>
            </c:strRef>
          </c:cat>
          <c:val>
            <c:numRef>
              <c:f>'Ratio_less class'!$B$8:$E$8</c:f>
              <c:numCache>
                <c:formatCode>0.0E+00</c:formatCode>
                <c:ptCount val="4"/>
                <c:pt idx="0">
                  <c:v>405934060.62590003</c:v>
                </c:pt>
                <c:pt idx="1">
                  <c:v>199773142.57709998</c:v>
                </c:pt>
                <c:pt idx="2">
                  <c:v>117010367.48410001</c:v>
                </c:pt>
                <c:pt idx="3">
                  <c:v>125469988.7546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5C3-4286-B7B8-268B24FBBED8}"/>
            </c:ext>
          </c:extLst>
        </c:ser>
        <c:ser>
          <c:idx val="4"/>
          <c:order val="1"/>
          <c:tx>
            <c:strRef>
              <c:f>'Ratio_less class'!$A$6</c:f>
              <c:strCache>
                <c:ptCount val="1"/>
                <c:pt idx="0">
                  <c:v>Hydrocarbons</c:v>
                </c:pt>
              </c:strCache>
            </c:strRef>
          </c:tx>
          <c:spPr>
            <a:solidFill>
              <a:srgbClr val="6A994E"/>
            </a:solidFill>
            <a:ln>
              <a:noFill/>
            </a:ln>
            <a:effectLst/>
          </c:spPr>
          <c:invertIfNegative val="0"/>
          <c:cat>
            <c:strRef>
              <c:f>'Ratio_less class'!$B$1:$E$1</c:f>
              <c:strCache>
                <c:ptCount val="4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</c:strCache>
            </c:strRef>
          </c:cat>
          <c:val>
            <c:numRef>
              <c:f>'Ratio_less class'!$B$6:$E$6</c:f>
              <c:numCache>
                <c:formatCode>0.0E+00</c:formatCode>
                <c:ptCount val="4"/>
                <c:pt idx="0">
                  <c:v>179651957.37</c:v>
                </c:pt>
                <c:pt idx="1">
                  <c:v>90851263.363000005</c:v>
                </c:pt>
                <c:pt idx="2">
                  <c:v>45040169.5</c:v>
                </c:pt>
                <c:pt idx="3">
                  <c:v>77641384.274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5C3-4286-B7B8-268B24FBBED8}"/>
            </c:ext>
          </c:extLst>
        </c:ser>
        <c:ser>
          <c:idx val="5"/>
          <c:order val="2"/>
          <c:tx>
            <c:strRef>
              <c:f>'Ratio_less class'!$A$7</c:f>
              <c:strCache>
                <c:ptCount val="1"/>
                <c:pt idx="0">
                  <c:v>Alcohol</c:v>
                </c:pt>
              </c:strCache>
            </c:strRef>
          </c:tx>
          <c:spPr>
            <a:solidFill>
              <a:srgbClr val="B5E2FA"/>
            </a:solidFill>
            <a:ln>
              <a:noFill/>
            </a:ln>
            <a:effectLst/>
          </c:spPr>
          <c:invertIfNegative val="0"/>
          <c:cat>
            <c:strRef>
              <c:f>'Ratio_less class'!$B$1:$E$1</c:f>
              <c:strCache>
                <c:ptCount val="4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</c:strCache>
            </c:strRef>
          </c:cat>
          <c:val>
            <c:numRef>
              <c:f>'Ratio_less class'!$B$7:$E$7</c:f>
              <c:numCache>
                <c:formatCode>0.0E+00</c:formatCode>
                <c:ptCount val="4"/>
                <c:pt idx="0">
                  <c:v>100030165.95999999</c:v>
                </c:pt>
                <c:pt idx="1">
                  <c:v>58171606.222999997</c:v>
                </c:pt>
                <c:pt idx="2">
                  <c:v>39530097.759999998</c:v>
                </c:pt>
                <c:pt idx="3">
                  <c:v>43127481.4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5C3-4286-B7B8-268B24FBBED8}"/>
            </c:ext>
          </c:extLst>
        </c:ser>
        <c:ser>
          <c:idx val="3"/>
          <c:order val="3"/>
          <c:tx>
            <c:strRef>
              <c:f>'Ratio_less class'!$A$5</c:f>
              <c:strCache>
                <c:ptCount val="1"/>
                <c:pt idx="0">
                  <c:v>Ester</c:v>
                </c:pt>
              </c:strCache>
            </c:strRef>
          </c:tx>
          <c:spPr>
            <a:solidFill>
              <a:srgbClr val="83C5BE"/>
            </a:solidFill>
            <a:ln>
              <a:noFill/>
            </a:ln>
            <a:effectLst/>
          </c:spPr>
          <c:invertIfNegative val="0"/>
          <c:cat>
            <c:strRef>
              <c:f>'Ratio_less class'!$B$1:$E$1</c:f>
              <c:strCache>
                <c:ptCount val="4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</c:strCache>
            </c:strRef>
          </c:cat>
          <c:val>
            <c:numRef>
              <c:f>'Ratio_less class'!$B$5:$E$5</c:f>
              <c:numCache>
                <c:formatCode>0.0E+00</c:formatCode>
                <c:ptCount val="4"/>
                <c:pt idx="0">
                  <c:v>186772917.58000001</c:v>
                </c:pt>
                <c:pt idx="1">
                  <c:v>107813377.94</c:v>
                </c:pt>
                <c:pt idx="2">
                  <c:v>68471459.513999999</c:v>
                </c:pt>
                <c:pt idx="3">
                  <c:v>81096653.349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5C3-4286-B7B8-268B24FBBED8}"/>
            </c:ext>
          </c:extLst>
        </c:ser>
        <c:ser>
          <c:idx val="2"/>
          <c:order val="4"/>
          <c:tx>
            <c:strRef>
              <c:f>'Ratio_less class'!$A$4</c:f>
              <c:strCache>
                <c:ptCount val="1"/>
                <c:pt idx="0">
                  <c:v>Heterocyclics</c:v>
                </c:pt>
              </c:strCache>
            </c:strRef>
          </c:tx>
          <c:spPr>
            <a:solidFill>
              <a:srgbClr val="68B5C9"/>
            </a:solidFill>
            <a:ln>
              <a:noFill/>
            </a:ln>
            <a:effectLst/>
          </c:spPr>
          <c:invertIfNegative val="0"/>
          <c:cat>
            <c:strRef>
              <c:f>'Ratio_less class'!$B$1:$E$1</c:f>
              <c:strCache>
                <c:ptCount val="4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</c:strCache>
            </c:strRef>
          </c:cat>
          <c:val>
            <c:numRef>
              <c:f>'Ratio_less class'!$B$4:$E$4</c:f>
              <c:numCache>
                <c:formatCode>0.0E+00</c:formatCode>
                <c:ptCount val="4"/>
                <c:pt idx="0">
                  <c:v>263592905.91</c:v>
                </c:pt>
                <c:pt idx="1">
                  <c:v>145621132.38999999</c:v>
                </c:pt>
                <c:pt idx="2">
                  <c:v>94595420.144999996</c:v>
                </c:pt>
                <c:pt idx="3">
                  <c:v>101230159.23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5C3-4286-B7B8-268B24FBBED8}"/>
            </c:ext>
          </c:extLst>
        </c:ser>
        <c:ser>
          <c:idx val="1"/>
          <c:order val="5"/>
          <c:tx>
            <c:strRef>
              <c:f>'Ratio_less class'!$A$3</c:f>
              <c:strCache>
                <c:ptCount val="1"/>
                <c:pt idx="0">
                  <c:v>Ketone</c:v>
                </c:pt>
              </c:strCache>
            </c:strRef>
          </c:tx>
          <c:spPr>
            <a:solidFill>
              <a:srgbClr val="EDDEA4"/>
            </a:solidFill>
            <a:ln>
              <a:noFill/>
            </a:ln>
            <a:effectLst/>
          </c:spPr>
          <c:invertIfNegative val="0"/>
          <c:cat>
            <c:strRef>
              <c:f>'Ratio_less class'!$B$1:$E$1</c:f>
              <c:strCache>
                <c:ptCount val="4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</c:strCache>
            </c:strRef>
          </c:cat>
          <c:val>
            <c:numRef>
              <c:f>'Ratio_less class'!$B$3:$E$3</c:f>
              <c:numCache>
                <c:formatCode>0.0E+00</c:formatCode>
                <c:ptCount val="4"/>
                <c:pt idx="0">
                  <c:v>268542969.69</c:v>
                </c:pt>
                <c:pt idx="1">
                  <c:v>159709511.06999999</c:v>
                </c:pt>
                <c:pt idx="2">
                  <c:v>93373424.016000003</c:v>
                </c:pt>
                <c:pt idx="3">
                  <c:v>128332191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85C3-4286-B7B8-268B24FBBED8}"/>
            </c:ext>
          </c:extLst>
        </c:ser>
        <c:ser>
          <c:idx val="0"/>
          <c:order val="6"/>
          <c:tx>
            <c:strRef>
              <c:f>'Ratio_less class'!$A$2</c:f>
              <c:strCache>
                <c:ptCount val="1"/>
                <c:pt idx="0">
                  <c:v>Terpenoids</c:v>
                </c:pt>
              </c:strCache>
            </c:strRef>
          </c:tx>
          <c:spPr>
            <a:solidFill>
              <a:srgbClr val="F7A072"/>
            </a:solidFill>
            <a:ln>
              <a:noFill/>
            </a:ln>
            <a:effectLst/>
          </c:spPr>
          <c:invertIfNegative val="0"/>
          <c:cat>
            <c:strRef>
              <c:f>'Ratio_less class'!$B$1:$E$1</c:f>
              <c:strCache>
                <c:ptCount val="4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</c:strCache>
            </c:strRef>
          </c:cat>
          <c:val>
            <c:numRef>
              <c:f>'Ratio_less class'!$B$2:$E$2</c:f>
              <c:numCache>
                <c:formatCode>0.0E+00</c:formatCode>
                <c:ptCount val="4"/>
                <c:pt idx="0">
                  <c:v>1411171386.0999999</c:v>
                </c:pt>
                <c:pt idx="1">
                  <c:v>633091766.89999998</c:v>
                </c:pt>
                <c:pt idx="2">
                  <c:v>313218696.36000001</c:v>
                </c:pt>
                <c:pt idx="3">
                  <c:v>335527460.91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85C3-4286-B7B8-268B24FBBE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641911631"/>
        <c:axId val="641910191"/>
      </c:barChart>
      <c:catAx>
        <c:axId val="641911631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5875" cap="sq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641910191"/>
        <c:crosses val="autoZero"/>
        <c:auto val="1"/>
        <c:lblAlgn val="ctr"/>
        <c:lblOffset val="100"/>
        <c:noMultiLvlLbl val="0"/>
      </c:catAx>
      <c:valAx>
        <c:axId val="64191019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ntensity</a:t>
                </a:r>
              </a:p>
            </c:rich>
          </c:tx>
          <c:layout>
            <c:manualLayout>
              <c:xMode val="edge"/>
              <c:yMode val="edge"/>
              <c:x val="2.0633724544581129E-2"/>
              <c:y val="0.3096799879841957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0.0E+00" sourceLinked="0"/>
        <c:majorTickMark val="out"/>
        <c:minorTickMark val="none"/>
        <c:tickLblPos val="nextTo"/>
        <c:spPr>
          <a:noFill/>
          <a:ln w="15875" cap="sq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641911631"/>
        <c:crosses val="autoZero"/>
        <c:crossBetween val="between"/>
        <c:majorUnit val="10000000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2.8754324220215313E-2"/>
          <c:y val="0.15190652289835802"/>
          <c:w val="0.49980789355333066"/>
          <c:h val="0.83466540627012653"/>
        </c:manualLayout>
      </c:layout>
      <c:pieChart>
        <c:varyColors val="1"/>
        <c:ser>
          <c:idx val="0"/>
          <c:order val="0"/>
          <c:tx>
            <c:strRef>
              <c:f>'[3 cor_meta_myb.xlsx]Pie_class'!$E$1</c:f>
              <c:strCache>
                <c:ptCount val="1"/>
                <c:pt idx="0">
                  <c:v>coun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E99-4575-B719-4F63766BCC3A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E99-4575-B719-4F63766BCC3A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7E99-4575-B719-4F63766BCC3A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7E99-4575-B719-4F63766BCC3A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7E99-4575-B719-4F63766BCC3A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7E99-4575-B719-4F63766BCC3A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7E99-4575-B719-4F63766BCC3A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7E99-4575-B719-4F63766BCC3A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7E99-4575-B719-4F63766BCC3A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7E99-4575-B719-4F63766BCC3A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7E99-4575-B719-4F63766BCC3A}"/>
              </c:ext>
            </c:extLst>
          </c:dPt>
          <c:dLbls>
            <c:dLbl>
              <c:idx val="1"/>
              <c:layout>
                <c:manualLayout>
                  <c:x val="-7.4932088867840918E-2"/>
                  <c:y val="-0.17594485364993748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7E99-4575-B719-4F63766BCC3A}"/>
                </c:ext>
              </c:extLst>
            </c:dLbl>
            <c:dLbl>
              <c:idx val="2"/>
              <c:layout>
                <c:manualLayout>
                  <c:x val="5.2359736893996429E-2"/>
                  <c:y val="-0.15716805290937311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7E99-4575-B719-4F63766BCC3A}"/>
                </c:ext>
              </c:extLst>
            </c:dLbl>
            <c:dLbl>
              <c:idx val="3"/>
              <c:layout>
                <c:manualLayout>
                  <c:x val="8.8425156344375019E-2"/>
                  <c:y val="-0.12196605630304788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7E99-4575-B719-4F63766BCC3A}"/>
                </c:ext>
              </c:extLst>
            </c:dLbl>
            <c:dLbl>
              <c:idx val="4"/>
              <c:layout>
                <c:manualLayout>
                  <c:x val="8.0001086495175955E-2"/>
                  <c:y val="5.5142876495587701E-3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7E99-4575-B719-4F63766BCC3A}"/>
                </c:ext>
              </c:extLst>
            </c:dLbl>
            <c:dLbl>
              <c:idx val="5"/>
              <c:layout>
                <c:manualLayout>
                  <c:x val="6.2001966888022779E-2"/>
                  <c:y val="6.0059710617131286E-2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7E99-4575-B719-4F63766BCC3A}"/>
                </c:ext>
              </c:extLst>
            </c:dLbl>
            <c:dLbl>
              <c:idx val="6"/>
              <c:layout>
                <c:manualLayout>
                  <c:x val="4.8837750813990138E-2"/>
                  <c:y val="9.9651861745085335E-2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7E99-4575-B719-4F63766BCC3A}"/>
                </c:ext>
              </c:extLst>
            </c:dLbl>
            <c:dLbl>
              <c:idx val="7"/>
              <c:layout>
                <c:manualLayout>
                  <c:x val="3.849925158314161E-2"/>
                  <c:y val="0.10648784164702652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7E99-4575-B719-4F63766BCC3A}"/>
                </c:ext>
              </c:extLst>
            </c:dLbl>
            <c:dLbl>
              <c:idx val="8"/>
              <c:layout>
                <c:manualLayout>
                  <c:x val="-1.6505396086585421E-2"/>
                  <c:y val="4.179569520838795E-3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1-7E99-4575-B719-4F63766BCC3A}"/>
                </c:ext>
              </c:extLst>
            </c:dLbl>
            <c:dLbl>
              <c:idx val="9"/>
              <c:layout>
                <c:manualLayout>
                  <c:x val="-1.2107164087933952E-2"/>
                  <c:y val="-1.6645198373949958E-2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3-7E99-4575-B719-4F63766BCC3A}"/>
                </c:ext>
              </c:extLst>
            </c:dLbl>
            <c:dLbl>
              <c:idx val="10"/>
              <c:layout>
                <c:manualLayout>
                  <c:x val="3.5317935650871775E-2"/>
                  <c:y val="-3.1528611693986804E-2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5-7E99-4575-B719-4F63766BCC3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CN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[3 cor_meta_myb.xlsx]Pie_class'!$D$2:$D$12</c:f>
              <c:strCache>
                <c:ptCount val="11"/>
                <c:pt idx="0">
                  <c:v>Terpenoids</c:v>
                </c:pt>
                <c:pt idx="1">
                  <c:v>Ester</c:v>
                </c:pt>
                <c:pt idx="2">
                  <c:v>Heterocyclic compound</c:v>
                </c:pt>
                <c:pt idx="3">
                  <c:v>Ketone</c:v>
                </c:pt>
                <c:pt idx="4">
                  <c:v>Aldehyde</c:v>
                </c:pt>
                <c:pt idx="5">
                  <c:v>Aromatics</c:v>
                </c:pt>
                <c:pt idx="6">
                  <c:v>Alcohol</c:v>
                </c:pt>
                <c:pt idx="7">
                  <c:v>Acid</c:v>
                </c:pt>
                <c:pt idx="8">
                  <c:v>Sulfur compounds</c:v>
                </c:pt>
                <c:pt idx="9">
                  <c:v>Phenol</c:v>
                </c:pt>
                <c:pt idx="10">
                  <c:v>Hydrocarbons</c:v>
                </c:pt>
              </c:strCache>
            </c:strRef>
          </c:cat>
          <c:val>
            <c:numRef>
              <c:f>'[3 cor_meta_myb.xlsx]Pie_class'!$E$2:$E$12</c:f>
              <c:numCache>
                <c:formatCode>General</c:formatCode>
                <c:ptCount val="11"/>
                <c:pt idx="0">
                  <c:v>31</c:v>
                </c:pt>
                <c:pt idx="1">
                  <c:v>15</c:v>
                </c:pt>
                <c:pt idx="2">
                  <c:v>11</c:v>
                </c:pt>
                <c:pt idx="3">
                  <c:v>9</c:v>
                </c:pt>
                <c:pt idx="4">
                  <c:v>6</c:v>
                </c:pt>
                <c:pt idx="5">
                  <c:v>5</c:v>
                </c:pt>
                <c:pt idx="6">
                  <c:v>5</c:v>
                </c:pt>
                <c:pt idx="7">
                  <c:v>4</c:v>
                </c:pt>
                <c:pt idx="8">
                  <c:v>3</c:v>
                </c:pt>
                <c:pt idx="9">
                  <c:v>2</c:v>
                </c:pt>
                <c:pt idx="1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7E99-4575-B719-4F63766BCC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2976327358253759"/>
          <c:y val="0.21802193921010532"/>
          <c:w val="0.36595381574127739"/>
          <c:h val="0.7271376533078484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zh-CN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9B487-8DF6-4050-9314-DBF2D2FE49EB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0C1C3-AB57-434E-BE39-CFFEE9F3AB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1391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9B487-8DF6-4050-9314-DBF2D2FE49EB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0C1C3-AB57-434E-BE39-CFFEE9F3AB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24237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9B487-8DF6-4050-9314-DBF2D2FE49EB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0C1C3-AB57-434E-BE39-CFFEE9F3AB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77110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9B487-8DF6-4050-9314-DBF2D2FE49EB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0C1C3-AB57-434E-BE39-CFFEE9F3AB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57672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9B487-8DF6-4050-9314-DBF2D2FE49EB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0C1C3-AB57-434E-BE39-CFFEE9F3AB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001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9B487-8DF6-4050-9314-DBF2D2FE49EB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0C1C3-AB57-434E-BE39-CFFEE9F3AB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76682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9B487-8DF6-4050-9314-DBF2D2FE49EB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0C1C3-AB57-434E-BE39-CFFEE9F3AB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95291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9B487-8DF6-4050-9314-DBF2D2FE49EB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0C1C3-AB57-434E-BE39-CFFEE9F3AB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22183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9B487-8DF6-4050-9314-DBF2D2FE49EB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0C1C3-AB57-434E-BE39-CFFEE9F3AB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7785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9B487-8DF6-4050-9314-DBF2D2FE49EB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0C1C3-AB57-434E-BE39-CFFEE9F3AB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33409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zh-CN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9B487-8DF6-4050-9314-DBF2D2FE49EB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0C1C3-AB57-434E-BE39-CFFEE9F3AB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1733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8B9B487-8DF6-4050-9314-DBF2D2FE49EB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C80C1C3-AB57-434E-BE39-CFFEE9F3AB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4631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43CE3B8-96C5-5281-D96E-657CD3C59ECB}"/>
              </a:ext>
            </a:extLst>
          </p:cNvPr>
          <p:cNvSpPr txBox="1"/>
          <p:nvPr/>
        </p:nvSpPr>
        <p:spPr>
          <a:xfrm>
            <a:off x="431800" y="8576735"/>
            <a:ext cx="59944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ion intensity of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volatile organic compounds (VOCs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floret of each cultivar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different developmental stages (S1-S4) of 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hiang Mai Pink (CMP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he metabolite classes are derived from 906 VOCs based on their structures. the top six classes were shown, and the rest were summarized as the “other” group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1" name="Group 40">
            <a:extLst>
              <a:ext uri="{FF2B5EF4-FFF2-40B4-BE49-F238E27FC236}">
                <a16:creationId xmlns:a16="http://schemas.microsoft.com/office/drawing/2014/main" id="{374FCB67-628E-0EB5-3E32-8C1E1A55A47F}"/>
              </a:ext>
            </a:extLst>
          </p:cNvPr>
          <p:cNvGrpSpPr/>
          <p:nvPr/>
        </p:nvGrpSpPr>
        <p:grpSpPr>
          <a:xfrm>
            <a:off x="638210" y="1629115"/>
            <a:ext cx="5581580" cy="6647770"/>
            <a:chOff x="584809" y="1133220"/>
            <a:chExt cx="5581580" cy="6647770"/>
          </a:xfrm>
        </p:grpSpPr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297D29AD-B687-07A5-5248-E210F1AEB19C}"/>
                </a:ext>
              </a:extLst>
            </p:cNvPr>
            <p:cNvGrpSpPr/>
            <p:nvPr/>
          </p:nvGrpSpPr>
          <p:grpSpPr>
            <a:xfrm>
              <a:off x="587896" y="1133220"/>
              <a:ext cx="5578493" cy="3294970"/>
              <a:chOff x="1146157" y="2091163"/>
              <a:chExt cx="5578493" cy="3294970"/>
            </a:xfrm>
          </p:grpSpPr>
          <p:graphicFrame>
            <p:nvGraphicFramePr>
              <p:cNvPr id="31" name="图表 1">
                <a:extLst>
                  <a:ext uri="{FF2B5EF4-FFF2-40B4-BE49-F238E27FC236}">
                    <a16:creationId xmlns:a16="http://schemas.microsoft.com/office/drawing/2014/main" id="{C318DD38-644B-79C3-433F-99230414EC2D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782365920"/>
                  </p:ext>
                </p:extLst>
              </p:nvPr>
            </p:nvGraphicFramePr>
            <p:xfrm>
              <a:off x="1146157" y="2091163"/>
              <a:ext cx="5578493" cy="329497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pSp>
            <p:nvGrpSpPr>
              <p:cNvPr id="32" name="Group 31">
                <a:extLst>
                  <a:ext uri="{FF2B5EF4-FFF2-40B4-BE49-F238E27FC236}">
                    <a16:creationId xmlns:a16="http://schemas.microsoft.com/office/drawing/2014/main" id="{D0AB7238-09D7-9A21-7F84-970BD4147C6F}"/>
                  </a:ext>
                </a:extLst>
              </p:cNvPr>
              <p:cNvGrpSpPr/>
              <p:nvPr/>
            </p:nvGrpSpPr>
            <p:grpSpPr>
              <a:xfrm>
                <a:off x="2085976" y="5181599"/>
                <a:ext cx="4433888" cy="136219"/>
                <a:chOff x="2372975" y="6581473"/>
                <a:chExt cx="2219320" cy="75895"/>
              </a:xfrm>
            </p:grpSpPr>
            <p:sp>
              <p:nvSpPr>
                <p:cNvPr id="33" name="tx83">
                  <a:extLst>
                    <a:ext uri="{FF2B5EF4-FFF2-40B4-BE49-F238E27FC236}">
                      <a16:creationId xmlns:a16="http://schemas.microsoft.com/office/drawing/2014/main" id="{3F12A32C-FE70-47FE-5426-F8D0151C7774}"/>
                    </a:ext>
                  </a:extLst>
                </p:cNvPr>
                <p:cNvSpPr/>
                <p:nvPr/>
              </p:nvSpPr>
              <p:spPr>
                <a:xfrm>
                  <a:off x="2372975" y="6589443"/>
                  <a:ext cx="240877" cy="67925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>
                    <a:lnSpc>
                      <a:spcPts val="1200"/>
                    </a:lnSpc>
                  </a:pPr>
                  <a:r>
                    <a:rPr lang="en-US" sz="1000" b="1" dirty="0" err="1">
                      <a:solidFill>
                        <a:srgbClr val="000000">
                          <a:alpha val="100000"/>
                        </a:srgbClr>
                      </a:solidFill>
                      <a:latin typeface="Arial"/>
                      <a:cs typeface="Arial"/>
                    </a:rPr>
                    <a:t>SS</a:t>
                  </a:r>
                  <a:r>
                    <a:rPr lang="en-US" altLang="zh-CN" sz="1000" b="1" dirty="0" err="1">
                      <a:solidFill>
                        <a:srgbClr val="000000">
                          <a:alpha val="100000"/>
                        </a:srgbClr>
                      </a:solidFill>
                      <a:latin typeface="Arial"/>
                      <a:cs typeface="Arial"/>
                    </a:rPr>
                    <a:t>h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endParaRPr>
                </a:p>
              </p:txBody>
            </p:sp>
            <p:sp>
              <p:nvSpPr>
                <p:cNvPr id="34" name="tx84">
                  <a:extLst>
                    <a:ext uri="{FF2B5EF4-FFF2-40B4-BE49-F238E27FC236}">
                      <a16:creationId xmlns:a16="http://schemas.microsoft.com/office/drawing/2014/main" id="{4CE4EAB4-4A46-AA5F-4D4D-7CFAF6DB78AF}"/>
                    </a:ext>
                  </a:extLst>
                </p:cNvPr>
                <p:cNvSpPr/>
                <p:nvPr/>
              </p:nvSpPr>
              <p:spPr>
                <a:xfrm>
                  <a:off x="2644597" y="6581473"/>
                  <a:ext cx="260268" cy="75895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>
                    <a:lnSpc>
                      <a:spcPts val="1200"/>
                    </a:lnSpc>
                  </a:pPr>
                  <a:r>
                    <a:rPr lang="en-US" sz="1000" b="1">
                      <a:solidFill>
                        <a:srgbClr val="000000">
                          <a:alpha val="100000"/>
                        </a:srgbClr>
                      </a:solidFill>
                      <a:latin typeface="Arial"/>
                      <a:cs typeface="Arial"/>
                    </a:rPr>
                    <a:t>CMP</a:t>
                  </a:r>
                  <a:endParaRPr sz="1000" b="1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endParaRPr>
                </a:p>
              </p:txBody>
            </p:sp>
            <p:sp>
              <p:nvSpPr>
                <p:cNvPr id="35" name="tx85">
                  <a:extLst>
                    <a:ext uri="{FF2B5EF4-FFF2-40B4-BE49-F238E27FC236}">
                      <a16:creationId xmlns:a16="http://schemas.microsoft.com/office/drawing/2014/main" id="{9825027E-180F-1338-1B89-3E3BD8C634B9}"/>
                    </a:ext>
                  </a:extLst>
                </p:cNvPr>
                <p:cNvSpPr/>
                <p:nvPr/>
              </p:nvSpPr>
              <p:spPr>
                <a:xfrm>
                  <a:off x="2941523" y="6589443"/>
                  <a:ext cx="234299" cy="67925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>
                    <a:lnSpc>
                      <a:spcPts val="1200"/>
                    </a:lnSpc>
                  </a:pPr>
                  <a:r>
                    <a:rPr lang="en-US" sz="1000" b="1" dirty="0" err="1">
                      <a:solidFill>
                        <a:srgbClr val="000000">
                          <a:alpha val="100000"/>
                        </a:srgbClr>
                      </a:solidFill>
                      <a:latin typeface="Arial"/>
                      <a:cs typeface="Arial"/>
                    </a:rPr>
                    <a:t>SS</a:t>
                  </a:r>
                  <a:r>
                    <a:rPr lang="en-US" altLang="zh-CN" sz="1000" b="1" dirty="0" err="1">
                      <a:solidFill>
                        <a:srgbClr val="000000">
                          <a:alpha val="100000"/>
                        </a:srgbClr>
                      </a:solidFill>
                      <a:latin typeface="Arial"/>
                      <a:cs typeface="Arial"/>
                    </a:rPr>
                    <a:t>ha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endParaRPr>
                </a:p>
              </p:txBody>
            </p:sp>
            <p:sp>
              <p:nvSpPr>
                <p:cNvPr id="36" name="tx86">
                  <a:extLst>
                    <a:ext uri="{FF2B5EF4-FFF2-40B4-BE49-F238E27FC236}">
                      <a16:creationId xmlns:a16="http://schemas.microsoft.com/office/drawing/2014/main" id="{8A89250D-747D-A768-8E0E-D4ECF96B94B3}"/>
                    </a:ext>
                  </a:extLst>
                </p:cNvPr>
                <p:cNvSpPr/>
                <p:nvPr/>
              </p:nvSpPr>
              <p:spPr>
                <a:xfrm>
                  <a:off x="3274256" y="6588284"/>
                  <a:ext cx="136712" cy="6908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>
                    <a:lnSpc>
                      <a:spcPts val="1200"/>
                    </a:lnSpc>
                  </a:pPr>
                  <a:r>
                    <a:rPr lang="en-US" sz="1000" b="1" err="1">
                      <a:solidFill>
                        <a:srgbClr val="000000">
                          <a:alpha val="100000"/>
                        </a:srgbClr>
                      </a:solidFill>
                      <a:latin typeface="Arial"/>
                      <a:cs typeface="Arial"/>
                    </a:rPr>
                    <a:t>SSc</a:t>
                  </a:r>
                  <a:endParaRPr sz="1000" b="1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endParaRPr>
                </a:p>
              </p:txBody>
            </p:sp>
            <p:sp>
              <p:nvSpPr>
                <p:cNvPr id="37" name="tx87">
                  <a:extLst>
                    <a:ext uri="{FF2B5EF4-FFF2-40B4-BE49-F238E27FC236}">
                      <a16:creationId xmlns:a16="http://schemas.microsoft.com/office/drawing/2014/main" id="{4C1D853F-B9AE-F587-F2E7-AAE554FF5133}"/>
                    </a:ext>
                  </a:extLst>
                </p:cNvPr>
                <p:cNvSpPr/>
                <p:nvPr/>
              </p:nvSpPr>
              <p:spPr>
                <a:xfrm>
                  <a:off x="3463844" y="6587126"/>
                  <a:ext cx="325421" cy="7024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>
                    <a:lnSpc>
                      <a:spcPts val="1200"/>
                    </a:lnSpc>
                  </a:pPr>
                  <a:r>
                    <a:rPr lang="en-US" sz="1000" b="1">
                      <a:solidFill>
                        <a:srgbClr val="000000">
                          <a:alpha val="100000"/>
                        </a:srgbClr>
                      </a:solidFill>
                      <a:latin typeface="Arial"/>
                      <a:cs typeface="Arial"/>
                    </a:rPr>
                    <a:t>SW</a:t>
                  </a:r>
                  <a:endParaRPr sz="1000" b="1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endParaRPr>
                </a:p>
              </p:txBody>
            </p:sp>
            <p:sp>
              <p:nvSpPr>
                <p:cNvPr id="38" name="tx88">
                  <a:extLst>
                    <a:ext uri="{FF2B5EF4-FFF2-40B4-BE49-F238E27FC236}">
                      <a16:creationId xmlns:a16="http://schemas.microsoft.com/office/drawing/2014/main" id="{C682A06C-0212-BC0C-3DC6-B62E4B7B7A2D}"/>
                    </a:ext>
                  </a:extLst>
                </p:cNvPr>
                <p:cNvSpPr/>
                <p:nvPr/>
              </p:nvSpPr>
              <p:spPr>
                <a:xfrm>
                  <a:off x="3829125" y="6589443"/>
                  <a:ext cx="162739" cy="67925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>
                    <a:lnSpc>
                      <a:spcPts val="1200"/>
                    </a:lnSpc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Arial"/>
                      <a:cs typeface="Arial"/>
                    </a:rPr>
                    <a:t>HY</a:t>
                  </a:r>
                </a:p>
              </p:txBody>
            </p:sp>
            <p:sp>
              <p:nvSpPr>
                <p:cNvPr id="39" name="tx89">
                  <a:extLst>
                    <a:ext uri="{FF2B5EF4-FFF2-40B4-BE49-F238E27FC236}">
                      <a16:creationId xmlns:a16="http://schemas.microsoft.com/office/drawing/2014/main" id="{E92920E2-A4F2-0040-6E1D-AEB3E9FBAB83}"/>
                    </a:ext>
                  </a:extLst>
                </p:cNvPr>
                <p:cNvSpPr/>
                <p:nvPr/>
              </p:nvSpPr>
              <p:spPr>
                <a:xfrm>
                  <a:off x="4109863" y="6589443"/>
                  <a:ext cx="169146" cy="67925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>
                    <a:lnSpc>
                      <a:spcPts val="1200"/>
                    </a:lnSpc>
                  </a:pPr>
                  <a:r>
                    <a:rPr lang="en-US" sz="1000" b="1">
                      <a:solidFill>
                        <a:srgbClr val="000000">
                          <a:alpha val="100000"/>
                        </a:srgbClr>
                      </a:solidFill>
                      <a:latin typeface="Arial"/>
                      <a:cs typeface="Arial"/>
                    </a:rPr>
                    <a:t>Da</a:t>
                  </a:r>
                  <a:endParaRPr sz="1000" b="1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endParaRPr>
                </a:p>
              </p:txBody>
            </p:sp>
            <p:sp>
              <p:nvSpPr>
                <p:cNvPr id="40" name="tx90">
                  <a:extLst>
                    <a:ext uri="{FF2B5EF4-FFF2-40B4-BE49-F238E27FC236}">
                      <a16:creationId xmlns:a16="http://schemas.microsoft.com/office/drawing/2014/main" id="{D9480052-8851-80FE-E87C-3E48E5E9289D}"/>
                    </a:ext>
                  </a:extLst>
                </p:cNvPr>
                <p:cNvSpPr/>
                <p:nvPr/>
              </p:nvSpPr>
              <p:spPr>
                <a:xfrm>
                  <a:off x="4364460" y="6589443"/>
                  <a:ext cx="227835" cy="67925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>
                    <a:lnSpc>
                      <a:spcPts val="1200"/>
                    </a:lnSpc>
                  </a:pPr>
                  <a:r>
                    <a:rPr lang="en-US" sz="1000" b="1">
                      <a:solidFill>
                        <a:srgbClr val="000000">
                          <a:alpha val="100000"/>
                        </a:srgbClr>
                      </a:solidFill>
                      <a:latin typeface="Arial"/>
                      <a:cs typeface="Arial"/>
                    </a:rPr>
                    <a:t>YK</a:t>
                  </a:r>
                  <a:endParaRPr sz="1000" b="1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endParaRPr>
                </a:p>
              </p:txBody>
            </p:sp>
          </p:grpSp>
        </p:grp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456B8AE-90AD-5CF6-7FE2-CBE2C3539F99}"/>
                </a:ext>
              </a:extLst>
            </p:cNvPr>
            <p:cNvSpPr txBox="1"/>
            <p:nvPr/>
          </p:nvSpPr>
          <p:spPr>
            <a:xfrm>
              <a:off x="584809" y="1294650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CCDE295-B622-AAC0-8E31-9EA056CA805B}"/>
                </a:ext>
              </a:extLst>
            </p:cNvPr>
            <p:cNvSpPr txBox="1"/>
            <p:nvPr/>
          </p:nvSpPr>
          <p:spPr>
            <a:xfrm>
              <a:off x="584809" y="4705724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7" name="Chart 6">
              <a:extLst>
                <a:ext uri="{FF2B5EF4-FFF2-40B4-BE49-F238E27FC236}">
                  <a16:creationId xmlns:a16="http://schemas.microsoft.com/office/drawing/2014/main" id="{7D38AAE1-CB31-5A09-8065-C6589BB33C1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22289916"/>
                </p:ext>
              </p:extLst>
            </p:nvPr>
          </p:nvGraphicFramePr>
          <p:xfrm>
            <a:off x="653682" y="4711699"/>
            <a:ext cx="3715810" cy="306929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ACE78EEE-D32E-F581-DFE9-3778DB1F1EE3}"/>
                </a:ext>
              </a:extLst>
            </p:cNvPr>
            <p:cNvGrpSpPr/>
            <p:nvPr/>
          </p:nvGrpSpPr>
          <p:grpSpPr>
            <a:xfrm>
              <a:off x="3840153" y="4995710"/>
              <a:ext cx="2265608" cy="443098"/>
              <a:chOff x="929235" y="5045523"/>
              <a:chExt cx="2265608" cy="443098"/>
            </a:xfrm>
          </p:grpSpPr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260FD6A3-EC56-B7E0-3B0F-4EC3E34ABE1B}"/>
                  </a:ext>
                </a:extLst>
              </p:cNvPr>
              <p:cNvGrpSpPr/>
              <p:nvPr/>
            </p:nvGrpSpPr>
            <p:grpSpPr>
              <a:xfrm>
                <a:off x="929235" y="5045812"/>
                <a:ext cx="792408" cy="200055"/>
                <a:chOff x="719685" y="5274412"/>
                <a:chExt cx="792408" cy="200055"/>
              </a:xfrm>
            </p:grpSpPr>
            <p:sp>
              <p:nvSpPr>
                <p:cNvPr id="28" name="rc55">
                  <a:extLst>
                    <a:ext uri="{FF2B5EF4-FFF2-40B4-BE49-F238E27FC236}">
                      <a16:creationId xmlns:a16="http://schemas.microsoft.com/office/drawing/2014/main" id="{92B5F611-79BE-E143-5AE2-7D2728AAF584}"/>
                    </a:ext>
                  </a:extLst>
                </p:cNvPr>
                <p:cNvSpPr/>
                <p:nvPr/>
              </p:nvSpPr>
              <p:spPr>
                <a:xfrm>
                  <a:off x="719685" y="5342941"/>
                  <a:ext cx="198035" cy="62997"/>
                </a:xfrm>
                <a:prstGeom prst="rect">
                  <a:avLst/>
                </a:prstGeom>
                <a:solidFill>
                  <a:srgbClr val="F7A072"/>
                </a:solidFill>
                <a:ln w="3175" cap="flat">
                  <a:noFill/>
                  <a:prstDash val="solid"/>
                  <a:miter/>
                </a:ln>
              </p:spPr>
              <p:txBody>
                <a:bodyPr/>
                <a:lstStyle/>
                <a:p>
                  <a:endParaRPr sz="700"/>
                </a:p>
              </p:txBody>
            </p:sp>
            <p:sp>
              <p:nvSpPr>
                <p:cNvPr id="29" name="TextBox 283">
                  <a:extLst>
                    <a:ext uri="{FF2B5EF4-FFF2-40B4-BE49-F238E27FC236}">
                      <a16:creationId xmlns:a16="http://schemas.microsoft.com/office/drawing/2014/main" id="{EF76DB1F-8960-E984-173A-BE6981C0C4BA}"/>
                    </a:ext>
                  </a:extLst>
                </p:cNvPr>
                <p:cNvSpPr txBox="1"/>
                <p:nvPr/>
              </p:nvSpPr>
              <p:spPr>
                <a:xfrm>
                  <a:off x="845903" y="5274412"/>
                  <a:ext cx="666190" cy="200055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r>
                    <a:rPr lang="en-US" sz="7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Terpenoids</a:t>
                  </a:r>
                </a:p>
              </p:txBody>
            </p:sp>
          </p:grpSp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9107CBBB-1018-4C25-53D3-672999A14494}"/>
                  </a:ext>
                </a:extLst>
              </p:cNvPr>
              <p:cNvGrpSpPr/>
              <p:nvPr/>
            </p:nvGrpSpPr>
            <p:grpSpPr>
              <a:xfrm>
                <a:off x="2592935" y="5047707"/>
                <a:ext cx="601908" cy="200055"/>
                <a:chOff x="719685" y="6003382"/>
                <a:chExt cx="601908" cy="200055"/>
              </a:xfrm>
            </p:grpSpPr>
            <p:sp>
              <p:nvSpPr>
                <p:cNvPr id="26" name="rc61">
                  <a:extLst>
                    <a:ext uri="{FF2B5EF4-FFF2-40B4-BE49-F238E27FC236}">
                      <a16:creationId xmlns:a16="http://schemas.microsoft.com/office/drawing/2014/main" id="{65BF4489-D998-E5CA-475B-A21A83759AC2}"/>
                    </a:ext>
                  </a:extLst>
                </p:cNvPr>
                <p:cNvSpPr/>
                <p:nvPr/>
              </p:nvSpPr>
              <p:spPr>
                <a:xfrm>
                  <a:off x="719685" y="6071911"/>
                  <a:ext cx="198035" cy="62997"/>
                </a:xfrm>
                <a:prstGeom prst="rect">
                  <a:avLst/>
                </a:prstGeom>
                <a:solidFill>
                  <a:srgbClr val="7F7F7F"/>
                </a:solidFill>
                <a:ln w="3175" cap="flat">
                  <a:noFill/>
                  <a:prstDash val="solid"/>
                  <a:miter/>
                </a:ln>
              </p:spPr>
              <p:txBody>
                <a:bodyPr/>
                <a:lstStyle/>
                <a:p>
                  <a:endParaRPr sz="700"/>
                </a:p>
              </p:txBody>
            </p:sp>
            <p:sp>
              <p:nvSpPr>
                <p:cNvPr id="27" name="TextBox 284">
                  <a:extLst>
                    <a:ext uri="{FF2B5EF4-FFF2-40B4-BE49-F238E27FC236}">
                      <a16:creationId xmlns:a16="http://schemas.microsoft.com/office/drawing/2014/main" id="{B08241B4-DEC2-6AA1-0E24-888E9296DADA}"/>
                    </a:ext>
                  </a:extLst>
                </p:cNvPr>
                <p:cNvSpPr txBox="1"/>
                <p:nvPr/>
              </p:nvSpPr>
              <p:spPr>
                <a:xfrm>
                  <a:off x="845902" y="6003382"/>
                  <a:ext cx="475691" cy="200055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r>
                    <a:rPr lang="en-US" sz="7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Others</a:t>
                  </a:r>
                </a:p>
              </p:txBody>
            </p:sp>
          </p:grpSp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87CF70EF-95BF-F1EE-3CF5-6A7DB9B51532}"/>
                  </a:ext>
                </a:extLst>
              </p:cNvPr>
              <p:cNvGrpSpPr/>
              <p:nvPr/>
            </p:nvGrpSpPr>
            <p:grpSpPr>
              <a:xfrm>
                <a:off x="1843635" y="5166900"/>
                <a:ext cx="669790" cy="199350"/>
                <a:chOff x="719685" y="5768173"/>
                <a:chExt cx="669790" cy="199350"/>
              </a:xfrm>
            </p:grpSpPr>
            <p:sp>
              <p:nvSpPr>
                <p:cNvPr id="24" name="TextBox 285">
                  <a:extLst>
                    <a:ext uri="{FF2B5EF4-FFF2-40B4-BE49-F238E27FC236}">
                      <a16:creationId xmlns:a16="http://schemas.microsoft.com/office/drawing/2014/main" id="{CB7D6E65-AF15-B390-AD97-270848EA6552}"/>
                    </a:ext>
                  </a:extLst>
                </p:cNvPr>
                <p:cNvSpPr txBox="1"/>
                <p:nvPr/>
              </p:nvSpPr>
              <p:spPr>
                <a:xfrm>
                  <a:off x="845903" y="5768173"/>
                  <a:ext cx="543572" cy="199350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pPr>
                    <a:lnSpc>
                      <a:spcPts val="880"/>
                    </a:lnSpc>
                  </a:pPr>
                  <a:r>
                    <a:rPr lang="en-US" sz="700" b="1">
                      <a:latin typeface="Arial"/>
                      <a:cs typeface="Arial"/>
                    </a:rPr>
                    <a:t>Alcohol</a:t>
                  </a:r>
                </a:p>
              </p:txBody>
            </p:sp>
            <p:sp>
              <p:nvSpPr>
                <p:cNvPr id="25" name="rc59">
                  <a:extLst>
                    <a:ext uri="{FF2B5EF4-FFF2-40B4-BE49-F238E27FC236}">
                      <a16:creationId xmlns:a16="http://schemas.microsoft.com/office/drawing/2014/main" id="{1A5C1952-B304-61F7-D424-2BD841F071F9}"/>
                    </a:ext>
                  </a:extLst>
                </p:cNvPr>
                <p:cNvSpPr/>
                <p:nvPr/>
              </p:nvSpPr>
              <p:spPr>
                <a:xfrm>
                  <a:off x="719685" y="5836350"/>
                  <a:ext cx="198035" cy="62997"/>
                </a:xfrm>
                <a:prstGeom prst="rect">
                  <a:avLst/>
                </a:prstGeom>
                <a:solidFill>
                  <a:srgbClr val="B5E2FA"/>
                </a:solidFill>
                <a:ln w="3175" cap="flat">
                  <a:noFill/>
                  <a:prstDash val="solid"/>
                  <a:miter/>
                </a:ln>
              </p:spPr>
              <p:txBody>
                <a:bodyPr/>
                <a:lstStyle/>
                <a:p>
                  <a:endParaRPr sz="700"/>
                </a:p>
              </p:txBody>
            </p:sp>
          </p:grpSp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2D3A6694-78B5-5BEC-FA77-D99C5BCBC3F7}"/>
                  </a:ext>
                </a:extLst>
              </p:cNvPr>
              <p:cNvGrpSpPr/>
              <p:nvPr/>
            </p:nvGrpSpPr>
            <p:grpSpPr>
              <a:xfrm>
                <a:off x="1843635" y="5288277"/>
                <a:ext cx="963471" cy="199350"/>
                <a:chOff x="719685" y="5893351"/>
                <a:chExt cx="963471" cy="199350"/>
              </a:xfrm>
            </p:grpSpPr>
            <p:sp>
              <p:nvSpPr>
                <p:cNvPr id="22" name="rc60">
                  <a:extLst>
                    <a:ext uri="{FF2B5EF4-FFF2-40B4-BE49-F238E27FC236}">
                      <a16:creationId xmlns:a16="http://schemas.microsoft.com/office/drawing/2014/main" id="{F86DFAB8-76B9-C343-BB91-CCA217B2D490}"/>
                    </a:ext>
                  </a:extLst>
                </p:cNvPr>
                <p:cNvSpPr/>
                <p:nvPr/>
              </p:nvSpPr>
              <p:spPr>
                <a:xfrm>
                  <a:off x="719685" y="5961528"/>
                  <a:ext cx="198035" cy="62997"/>
                </a:xfrm>
                <a:prstGeom prst="rect">
                  <a:avLst/>
                </a:prstGeom>
                <a:solidFill>
                  <a:srgbClr val="6A994E"/>
                </a:solidFill>
                <a:ln w="3175" cap="flat">
                  <a:noFill/>
                  <a:prstDash val="solid"/>
                  <a:miter/>
                </a:ln>
              </p:spPr>
              <p:txBody>
                <a:bodyPr/>
                <a:lstStyle/>
                <a:p>
                  <a:endParaRPr sz="700"/>
                </a:p>
              </p:txBody>
            </p:sp>
            <p:sp>
              <p:nvSpPr>
                <p:cNvPr id="23" name="TextBox 286">
                  <a:extLst>
                    <a:ext uri="{FF2B5EF4-FFF2-40B4-BE49-F238E27FC236}">
                      <a16:creationId xmlns:a16="http://schemas.microsoft.com/office/drawing/2014/main" id="{FAA7F999-192B-B935-E371-9BA86E7FEA2A}"/>
                    </a:ext>
                  </a:extLst>
                </p:cNvPr>
                <p:cNvSpPr txBox="1"/>
                <p:nvPr/>
              </p:nvSpPr>
              <p:spPr>
                <a:xfrm>
                  <a:off x="845903" y="5893351"/>
                  <a:ext cx="837253" cy="199350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pPr>
                    <a:lnSpc>
                      <a:spcPts val="880"/>
                    </a:lnSpc>
                  </a:pPr>
                  <a:r>
                    <a:rPr lang="en-US" sz="700" b="1">
                      <a:latin typeface="Arial"/>
                      <a:cs typeface="Arial"/>
                    </a:rPr>
                    <a:t>Hydrocarbons</a:t>
                  </a:r>
                </a:p>
              </p:txBody>
            </p:sp>
          </p:grpSp>
          <p:grpSp>
            <p:nvGrpSpPr>
              <p:cNvPr id="13" name="Group 12">
                <a:extLst>
                  <a:ext uri="{FF2B5EF4-FFF2-40B4-BE49-F238E27FC236}">
                    <a16:creationId xmlns:a16="http://schemas.microsoft.com/office/drawing/2014/main" id="{F5D435EA-36C5-EC09-BF22-2C61D6943722}"/>
                  </a:ext>
                </a:extLst>
              </p:cNvPr>
              <p:cNvGrpSpPr/>
              <p:nvPr/>
            </p:nvGrpSpPr>
            <p:grpSpPr>
              <a:xfrm>
                <a:off x="1843635" y="5045523"/>
                <a:ext cx="559443" cy="199350"/>
                <a:chOff x="719685" y="5647285"/>
                <a:chExt cx="559443" cy="199350"/>
              </a:xfrm>
            </p:grpSpPr>
            <p:sp>
              <p:nvSpPr>
                <p:cNvPr id="20" name="rc58">
                  <a:extLst>
                    <a:ext uri="{FF2B5EF4-FFF2-40B4-BE49-F238E27FC236}">
                      <a16:creationId xmlns:a16="http://schemas.microsoft.com/office/drawing/2014/main" id="{D07667EC-62A5-2493-0079-78161E65920E}"/>
                    </a:ext>
                  </a:extLst>
                </p:cNvPr>
                <p:cNvSpPr/>
                <p:nvPr/>
              </p:nvSpPr>
              <p:spPr>
                <a:xfrm>
                  <a:off x="719685" y="5715462"/>
                  <a:ext cx="198035" cy="62997"/>
                </a:xfrm>
                <a:prstGeom prst="rect">
                  <a:avLst/>
                </a:prstGeom>
                <a:solidFill>
                  <a:srgbClr val="83C5BE"/>
                </a:solidFill>
                <a:ln w="3175" cap="flat">
                  <a:noFill/>
                  <a:prstDash val="solid"/>
                  <a:miter/>
                </a:ln>
              </p:spPr>
              <p:txBody>
                <a:bodyPr/>
                <a:lstStyle/>
                <a:p>
                  <a:endParaRPr sz="700"/>
                </a:p>
              </p:txBody>
            </p:sp>
            <p:sp>
              <p:nvSpPr>
                <p:cNvPr id="21" name="TextBox 287">
                  <a:extLst>
                    <a:ext uri="{FF2B5EF4-FFF2-40B4-BE49-F238E27FC236}">
                      <a16:creationId xmlns:a16="http://schemas.microsoft.com/office/drawing/2014/main" id="{DDE8F206-F059-1E05-EAFE-F6F9D2383CE7}"/>
                    </a:ext>
                  </a:extLst>
                </p:cNvPr>
                <p:cNvSpPr txBox="1"/>
                <p:nvPr/>
              </p:nvSpPr>
              <p:spPr>
                <a:xfrm>
                  <a:off x="845903" y="5647285"/>
                  <a:ext cx="433225" cy="199350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pPr>
                    <a:lnSpc>
                      <a:spcPts val="880"/>
                    </a:lnSpc>
                  </a:pPr>
                  <a:r>
                    <a:rPr lang="en-US" sz="700" b="1">
                      <a:latin typeface="Arial"/>
                      <a:cs typeface="Arial"/>
                    </a:rPr>
                    <a:t>Ester</a:t>
                  </a:r>
                </a:p>
              </p:txBody>
            </p:sp>
          </p:grpSp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7FCD0460-3580-8F3C-DF48-4DFC76B59071}"/>
                  </a:ext>
                </a:extLst>
              </p:cNvPr>
              <p:cNvGrpSpPr/>
              <p:nvPr/>
            </p:nvGrpSpPr>
            <p:grpSpPr>
              <a:xfrm>
                <a:off x="929235" y="5289271"/>
                <a:ext cx="939707" cy="199350"/>
                <a:chOff x="719685" y="5529012"/>
                <a:chExt cx="939707" cy="199350"/>
              </a:xfrm>
            </p:grpSpPr>
            <p:sp>
              <p:nvSpPr>
                <p:cNvPr id="18" name="rc57">
                  <a:extLst>
                    <a:ext uri="{FF2B5EF4-FFF2-40B4-BE49-F238E27FC236}">
                      <a16:creationId xmlns:a16="http://schemas.microsoft.com/office/drawing/2014/main" id="{A226FE98-3AA5-F1B9-4BD6-58EF468D9813}"/>
                    </a:ext>
                  </a:extLst>
                </p:cNvPr>
                <p:cNvSpPr/>
                <p:nvPr/>
              </p:nvSpPr>
              <p:spPr>
                <a:xfrm>
                  <a:off x="719685" y="5597189"/>
                  <a:ext cx="198035" cy="62997"/>
                </a:xfrm>
                <a:prstGeom prst="rect">
                  <a:avLst/>
                </a:prstGeom>
                <a:solidFill>
                  <a:srgbClr val="68B5C9"/>
                </a:solidFill>
                <a:ln w="3175" cap="flat">
                  <a:noFill/>
                  <a:prstDash val="solid"/>
                  <a:miter/>
                </a:ln>
              </p:spPr>
              <p:txBody>
                <a:bodyPr/>
                <a:lstStyle/>
                <a:p>
                  <a:endParaRPr sz="700"/>
                </a:p>
              </p:txBody>
            </p:sp>
            <p:sp>
              <p:nvSpPr>
                <p:cNvPr id="19" name="TextBox 288">
                  <a:extLst>
                    <a:ext uri="{FF2B5EF4-FFF2-40B4-BE49-F238E27FC236}">
                      <a16:creationId xmlns:a16="http://schemas.microsoft.com/office/drawing/2014/main" id="{D8C7ADA6-D60E-F814-D784-CD5D4DA8A486}"/>
                    </a:ext>
                  </a:extLst>
                </p:cNvPr>
                <p:cNvSpPr txBox="1"/>
                <p:nvPr/>
              </p:nvSpPr>
              <p:spPr>
                <a:xfrm>
                  <a:off x="845903" y="5529012"/>
                  <a:ext cx="813489" cy="199350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pPr>
                    <a:lnSpc>
                      <a:spcPts val="880"/>
                    </a:lnSpc>
                  </a:pPr>
                  <a:r>
                    <a:rPr lang="en-US" sz="700" b="1">
                      <a:latin typeface="Arial"/>
                      <a:cs typeface="Arial"/>
                    </a:rPr>
                    <a:t>Heterocyclic</a:t>
                  </a:r>
                  <a:r>
                    <a:rPr lang="en-US" altLang="zh-CN" sz="700" b="1">
                      <a:latin typeface="Arial"/>
                      <a:cs typeface="Arial"/>
                    </a:rPr>
                    <a:t>s</a:t>
                  </a:r>
                  <a:endParaRPr lang="en-US" sz="700" b="1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8DCA0D4A-1411-7F03-163F-9053B060CDD5}"/>
                  </a:ext>
                </a:extLst>
              </p:cNvPr>
              <p:cNvGrpSpPr/>
              <p:nvPr/>
            </p:nvGrpSpPr>
            <p:grpSpPr>
              <a:xfrm>
                <a:off x="929235" y="5167894"/>
                <a:ext cx="642628" cy="199350"/>
                <a:chOff x="719685" y="5411809"/>
                <a:chExt cx="642628" cy="199350"/>
              </a:xfrm>
            </p:grpSpPr>
            <p:sp>
              <p:nvSpPr>
                <p:cNvPr id="16" name="rc56">
                  <a:extLst>
                    <a:ext uri="{FF2B5EF4-FFF2-40B4-BE49-F238E27FC236}">
                      <a16:creationId xmlns:a16="http://schemas.microsoft.com/office/drawing/2014/main" id="{FAD7D0A5-A832-9077-9DBE-785062A7B7E2}"/>
                    </a:ext>
                  </a:extLst>
                </p:cNvPr>
                <p:cNvSpPr/>
                <p:nvPr/>
              </p:nvSpPr>
              <p:spPr>
                <a:xfrm>
                  <a:off x="719685" y="5479986"/>
                  <a:ext cx="198035" cy="62997"/>
                </a:xfrm>
                <a:prstGeom prst="rect">
                  <a:avLst/>
                </a:prstGeom>
                <a:solidFill>
                  <a:srgbClr val="EDDEA4"/>
                </a:solidFill>
                <a:ln w="3175" cap="flat">
                  <a:noFill/>
                  <a:prstDash val="solid"/>
                  <a:miter/>
                </a:ln>
              </p:spPr>
              <p:txBody>
                <a:bodyPr/>
                <a:lstStyle/>
                <a:p>
                  <a:endParaRPr sz="700"/>
                </a:p>
              </p:txBody>
            </p:sp>
            <p:sp>
              <p:nvSpPr>
                <p:cNvPr id="17" name="TextBox 289">
                  <a:extLst>
                    <a:ext uri="{FF2B5EF4-FFF2-40B4-BE49-F238E27FC236}">
                      <a16:creationId xmlns:a16="http://schemas.microsoft.com/office/drawing/2014/main" id="{0C611EA0-48E3-FAE4-3B91-F9707BF06A6D}"/>
                    </a:ext>
                  </a:extLst>
                </p:cNvPr>
                <p:cNvSpPr txBox="1"/>
                <p:nvPr/>
              </p:nvSpPr>
              <p:spPr>
                <a:xfrm>
                  <a:off x="845903" y="5411809"/>
                  <a:ext cx="516410" cy="199350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pPr>
                    <a:lnSpc>
                      <a:spcPts val="880"/>
                    </a:lnSpc>
                  </a:pPr>
                  <a:r>
                    <a:rPr lang="en-US" sz="700" b="1">
                      <a:latin typeface="Arial"/>
                      <a:cs typeface="Arial"/>
                    </a:rPr>
                    <a:t>Ketone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4379133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0C1FB9D8-EEAD-BD7E-EB29-B6AC64FBEB8A}"/>
              </a:ext>
            </a:extLst>
          </p:cNvPr>
          <p:cNvGrpSpPr/>
          <p:nvPr/>
        </p:nvGrpSpPr>
        <p:grpSpPr>
          <a:xfrm>
            <a:off x="1746382" y="2235219"/>
            <a:ext cx="2946137" cy="3012619"/>
            <a:chOff x="1590919" y="2431434"/>
            <a:chExt cx="2946137" cy="3012619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077130E8-72BB-E122-78CE-087DEBD2133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9553" r="34239"/>
            <a:stretch/>
          </p:blipFill>
          <p:spPr>
            <a:xfrm>
              <a:off x="2039274" y="2640983"/>
              <a:ext cx="2290762" cy="472331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E3A43444-B7AB-557E-9AA9-28F14F9E918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9611" r="34629"/>
            <a:stretch/>
          </p:blipFill>
          <p:spPr>
            <a:xfrm>
              <a:off x="2041656" y="3271858"/>
              <a:ext cx="2272505" cy="474884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B5CA0761-E62B-F131-115D-B8A6D7F2DDB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9552" r="34551"/>
            <a:stretch/>
          </p:blipFill>
          <p:spPr>
            <a:xfrm>
              <a:off x="2039274" y="3905061"/>
              <a:ext cx="2278062" cy="472331"/>
            </a:xfrm>
            <a:prstGeom prst="rect">
              <a:avLst/>
            </a:prstGeom>
          </p:spPr>
        </p:pic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631D831A-525A-8D10-2DA3-18AF15330E1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034511" y="2602884"/>
              <a:ext cx="3176" cy="2422668"/>
            </a:xfrm>
            <a:prstGeom prst="line">
              <a:avLst/>
            </a:prstGeom>
            <a:ln w="12700" cap="sq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Line 9">
              <a:extLst>
                <a:ext uri="{FF2B5EF4-FFF2-40B4-BE49-F238E27FC236}">
                  <a16:creationId xmlns:a16="http://schemas.microsoft.com/office/drawing/2014/main" id="{3DEB3958-2ADF-AB57-F700-522AAD55173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34511" y="3761902"/>
              <a:ext cx="22860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0" name="Line 9">
              <a:extLst>
                <a:ext uri="{FF2B5EF4-FFF2-40B4-BE49-F238E27FC236}">
                  <a16:creationId xmlns:a16="http://schemas.microsoft.com/office/drawing/2014/main" id="{2759BE3F-E3DC-B897-7A28-4CA27D81A55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34511" y="3126108"/>
              <a:ext cx="22860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08417D4-899D-0C1E-F157-A42DEE17C8BC}"/>
                </a:ext>
              </a:extLst>
            </p:cNvPr>
            <p:cNvSpPr txBox="1"/>
            <p:nvPr/>
          </p:nvSpPr>
          <p:spPr>
            <a:xfrm>
              <a:off x="2539336" y="309183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/>
                <a:t>1</a:t>
              </a:r>
              <a:endParaRPr lang="zh-CN" altLang="en-US" sz="800" b="1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B2BD96F-22BE-0E41-2039-4AF2D5A142CA}"/>
                </a:ext>
              </a:extLst>
            </p:cNvPr>
            <p:cNvSpPr txBox="1"/>
            <p:nvPr/>
          </p:nvSpPr>
          <p:spPr>
            <a:xfrm>
              <a:off x="2761586" y="414275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/>
                <a:t>2</a:t>
              </a:r>
              <a:endParaRPr lang="zh-CN" altLang="en-US" sz="800" b="1" dirty="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BE4A0F7-56D0-BE9D-C415-D8B6D0D95494}"/>
                </a:ext>
              </a:extLst>
            </p:cNvPr>
            <p:cNvSpPr txBox="1"/>
            <p:nvPr/>
          </p:nvSpPr>
          <p:spPr>
            <a:xfrm>
              <a:off x="2844136" y="371730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/>
                <a:t>3</a:t>
              </a:r>
              <a:endParaRPr lang="zh-CN" altLang="en-US" sz="800" b="1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DC11A23-4264-2A14-70A7-062C5853B9F3}"/>
                </a:ext>
              </a:extLst>
            </p:cNvPr>
            <p:cNvSpPr txBox="1"/>
            <p:nvPr/>
          </p:nvSpPr>
          <p:spPr>
            <a:xfrm>
              <a:off x="3348961" y="415863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/>
                <a:t>4</a:t>
              </a:r>
              <a:endParaRPr lang="zh-CN" altLang="en-US" sz="800" b="1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DD75021C-0D8F-A23B-709C-F3684B42269B}"/>
                </a:ext>
              </a:extLst>
            </p:cNvPr>
            <p:cNvSpPr txBox="1"/>
            <p:nvPr/>
          </p:nvSpPr>
          <p:spPr>
            <a:xfrm>
              <a:off x="3983961" y="285053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A9811C7-780F-BB81-D3B5-71A3DA81D80A}"/>
                </a:ext>
              </a:extLst>
            </p:cNvPr>
            <p:cNvSpPr txBox="1"/>
            <p:nvPr/>
          </p:nvSpPr>
          <p:spPr>
            <a:xfrm>
              <a:off x="2342486" y="2431434"/>
              <a:ext cx="3834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/>
                <a:t>DTT</a:t>
              </a:r>
              <a:endParaRPr lang="zh-CN" altLang="en-US" sz="800" b="1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321F092-753E-92F8-0566-DED66F20D80A}"/>
                </a:ext>
              </a:extLst>
            </p:cNvPr>
            <p:cNvSpPr txBox="1"/>
            <p:nvPr/>
          </p:nvSpPr>
          <p:spPr>
            <a:xfrm>
              <a:off x="3682335" y="2453659"/>
              <a:ext cx="8547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hr02HA2532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2F3CE90A-07D5-AD4D-1B64-1726F44578E2}"/>
                </a:ext>
              </a:extLst>
            </p:cNvPr>
            <p:cNvCxnSpPr/>
            <p:nvPr/>
          </p:nvCxnSpPr>
          <p:spPr>
            <a:xfrm>
              <a:off x="1996229" y="4374316"/>
              <a:ext cx="3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35A072F3-E421-5E04-9D11-CAB4FBB4D25B}"/>
                </a:ext>
              </a:extLst>
            </p:cNvPr>
            <p:cNvCxnSpPr/>
            <p:nvPr/>
          </p:nvCxnSpPr>
          <p:spPr>
            <a:xfrm>
              <a:off x="1996229" y="3900447"/>
              <a:ext cx="3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889BC767-87C1-B762-DEB2-12AF3257E5D9}"/>
                </a:ext>
              </a:extLst>
            </p:cNvPr>
            <p:cNvCxnSpPr/>
            <p:nvPr/>
          </p:nvCxnSpPr>
          <p:spPr>
            <a:xfrm>
              <a:off x="1996229" y="3267034"/>
              <a:ext cx="3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F688F053-FA32-045E-24B9-1B0F38F925D1}"/>
                </a:ext>
              </a:extLst>
            </p:cNvPr>
            <p:cNvCxnSpPr/>
            <p:nvPr/>
          </p:nvCxnSpPr>
          <p:spPr>
            <a:xfrm>
              <a:off x="1996229" y="2636003"/>
              <a:ext cx="3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D78DE80F-85F4-2495-4018-CB0B2E26763E}"/>
                </a:ext>
              </a:extLst>
            </p:cNvPr>
            <p:cNvCxnSpPr/>
            <p:nvPr/>
          </p:nvCxnSpPr>
          <p:spPr>
            <a:xfrm>
              <a:off x="1996229" y="3105109"/>
              <a:ext cx="3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BA97759A-1635-3046-107B-5F547ECE4208}"/>
                </a:ext>
              </a:extLst>
            </p:cNvPr>
            <p:cNvCxnSpPr/>
            <p:nvPr/>
          </p:nvCxnSpPr>
          <p:spPr>
            <a:xfrm>
              <a:off x="1996229" y="3743285"/>
              <a:ext cx="3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9CC7791-8C03-1F82-7C87-47567913B9B4}"/>
                </a:ext>
              </a:extLst>
            </p:cNvPr>
            <p:cNvSpPr txBox="1"/>
            <p:nvPr/>
          </p:nvSpPr>
          <p:spPr>
            <a:xfrm>
              <a:off x="1741457" y="3805889"/>
              <a:ext cx="3337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/>
                <a:t>100</a:t>
              </a:r>
              <a:endParaRPr lang="zh-CN" altLang="en-US" sz="700" b="1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4B0E3A53-99AC-CBE4-B2DC-18582A0B419A}"/>
                </a:ext>
              </a:extLst>
            </p:cNvPr>
            <p:cNvSpPr txBox="1"/>
            <p:nvPr/>
          </p:nvSpPr>
          <p:spPr>
            <a:xfrm>
              <a:off x="1840843" y="4276584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/>
                <a:t>0</a:t>
              </a:r>
              <a:endParaRPr lang="zh-CN" altLang="en-US" sz="700" b="1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9F4485AE-9933-5ED7-C810-7A7B21FDE722}"/>
                </a:ext>
              </a:extLst>
            </p:cNvPr>
            <p:cNvSpPr txBox="1"/>
            <p:nvPr/>
          </p:nvSpPr>
          <p:spPr>
            <a:xfrm>
              <a:off x="1741457" y="3172476"/>
              <a:ext cx="3337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/>
                <a:t>100</a:t>
              </a:r>
              <a:endParaRPr lang="zh-CN" altLang="en-US" sz="700" b="1" dirty="0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185E7842-1F9E-2CF5-0714-29C526087680}"/>
                </a:ext>
              </a:extLst>
            </p:cNvPr>
            <p:cNvSpPr txBox="1"/>
            <p:nvPr/>
          </p:nvSpPr>
          <p:spPr>
            <a:xfrm>
              <a:off x="1840843" y="3643171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/>
                <a:t>0</a:t>
              </a:r>
              <a:endParaRPr lang="zh-CN" altLang="en-US" sz="700" b="1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C641FD77-27E8-F6FA-BC89-7BE3A86DF239}"/>
                </a:ext>
              </a:extLst>
            </p:cNvPr>
            <p:cNvSpPr txBox="1"/>
            <p:nvPr/>
          </p:nvSpPr>
          <p:spPr>
            <a:xfrm>
              <a:off x="1741457" y="2539063"/>
              <a:ext cx="3337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/>
                <a:t>100</a:t>
              </a:r>
              <a:endParaRPr lang="zh-CN" altLang="en-US" sz="700" b="1" dirty="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274674F4-DD79-8205-59E8-1D5BD39DFD5F}"/>
                </a:ext>
              </a:extLst>
            </p:cNvPr>
            <p:cNvSpPr txBox="1"/>
            <p:nvPr/>
          </p:nvSpPr>
          <p:spPr>
            <a:xfrm>
              <a:off x="1840843" y="3009758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/>
                <a:t>0</a:t>
              </a:r>
              <a:endParaRPr lang="zh-CN" altLang="en-US" sz="700" b="1" dirty="0"/>
            </a:p>
          </p:txBody>
        </p:sp>
        <p:sp>
          <p:nvSpPr>
            <p:cNvPr id="30" name="TextBox 54">
              <a:extLst>
                <a:ext uri="{FF2B5EF4-FFF2-40B4-BE49-F238E27FC236}">
                  <a16:creationId xmlns:a16="http://schemas.microsoft.com/office/drawing/2014/main" id="{5D9BC2A8-04F8-14C3-6FD8-24475AF10AC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028425" y="3673481"/>
              <a:ext cx="134043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800" b="1" dirty="0"/>
                <a:t>Relative abundance (%)</a:t>
              </a:r>
              <a:endParaRPr lang="zh-CN" altLang="en-US" sz="800" b="1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09DF51BA-2DAD-D9AC-A302-FAD57900FF7A}"/>
                </a:ext>
              </a:extLst>
            </p:cNvPr>
            <p:cNvSpPr txBox="1"/>
            <p:nvPr/>
          </p:nvSpPr>
          <p:spPr>
            <a:xfrm>
              <a:off x="3682335" y="3120409"/>
              <a:ext cx="8547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hr02HA2534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692F4714-662B-7C76-FC9B-74BD68485F9C}"/>
                </a:ext>
              </a:extLst>
            </p:cNvPr>
            <p:cNvSpPr txBox="1"/>
            <p:nvPr/>
          </p:nvSpPr>
          <p:spPr>
            <a:xfrm>
              <a:off x="3682335" y="3764299"/>
              <a:ext cx="8547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hr02HA2528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2B709189-7397-B23F-A7E0-698D226E525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9499" r="34373"/>
            <a:stretch/>
          </p:blipFill>
          <p:spPr>
            <a:xfrm>
              <a:off x="2034511" y="4497915"/>
              <a:ext cx="2289175" cy="502522"/>
            </a:xfrm>
            <a:prstGeom prst="rect">
              <a:avLst/>
            </a:prstGeom>
          </p:spPr>
        </p:pic>
        <p:sp>
          <p:nvSpPr>
            <p:cNvPr id="34" name="Line 9">
              <a:extLst>
                <a:ext uri="{FF2B5EF4-FFF2-40B4-BE49-F238E27FC236}">
                  <a16:creationId xmlns:a16="http://schemas.microsoft.com/office/drawing/2014/main" id="{90AD77C3-00FF-18F4-4BE7-4D932B14F11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34511" y="4389758"/>
              <a:ext cx="22860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3932E031-7D48-890B-204B-0BC4B89DF296}"/>
                </a:ext>
              </a:extLst>
            </p:cNvPr>
            <p:cNvCxnSpPr/>
            <p:nvPr/>
          </p:nvCxnSpPr>
          <p:spPr>
            <a:xfrm>
              <a:off x="1996229" y="4530684"/>
              <a:ext cx="3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FB10B4B7-6747-03CE-D362-761A87F9667B}"/>
                </a:ext>
              </a:extLst>
            </p:cNvPr>
            <p:cNvCxnSpPr/>
            <p:nvPr/>
          </p:nvCxnSpPr>
          <p:spPr>
            <a:xfrm>
              <a:off x="1996229" y="4368759"/>
              <a:ext cx="3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1CD8D9D4-1F32-A713-8FCE-3D35528335A0}"/>
                </a:ext>
              </a:extLst>
            </p:cNvPr>
            <p:cNvCxnSpPr/>
            <p:nvPr/>
          </p:nvCxnSpPr>
          <p:spPr>
            <a:xfrm>
              <a:off x="1996229" y="5006935"/>
              <a:ext cx="3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E83016CF-5DB1-8571-313A-53EB088EE08B}"/>
                </a:ext>
              </a:extLst>
            </p:cNvPr>
            <p:cNvSpPr txBox="1"/>
            <p:nvPr/>
          </p:nvSpPr>
          <p:spPr>
            <a:xfrm>
              <a:off x="3689955" y="4384059"/>
              <a:ext cx="63350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Cold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TF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AFCB13B6-952C-3B3F-FC17-468C4345DF4D}"/>
                </a:ext>
              </a:extLst>
            </p:cNvPr>
            <p:cNvGrpSpPr/>
            <p:nvPr/>
          </p:nvGrpSpPr>
          <p:grpSpPr>
            <a:xfrm>
              <a:off x="1884493" y="5019996"/>
              <a:ext cx="2590841" cy="424057"/>
              <a:chOff x="1804988" y="6322362"/>
              <a:chExt cx="2590841" cy="424057"/>
            </a:xfrm>
          </p:grpSpPr>
          <p:sp>
            <p:nvSpPr>
              <p:cNvPr id="42" name="Line 9">
                <a:extLst>
                  <a:ext uri="{FF2B5EF4-FFF2-40B4-BE49-F238E27FC236}">
                    <a16:creationId xmlns:a16="http://schemas.microsoft.com/office/drawing/2014/main" id="{639B239D-30B0-846D-86B8-984DEC291B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52625" y="6322362"/>
                <a:ext cx="22860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43" name="Line 179">
                <a:extLst>
                  <a:ext uri="{FF2B5EF4-FFF2-40B4-BE49-F238E27FC236}">
                    <a16:creationId xmlns:a16="http://schemas.microsoft.com/office/drawing/2014/main" id="{8904AC13-E521-CA45-4FF9-2BA8A4A2B6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55854" y="6325537"/>
                <a:ext cx="0" cy="40900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44" name="Line 181">
                <a:extLst>
                  <a:ext uri="{FF2B5EF4-FFF2-40B4-BE49-F238E27FC236}">
                    <a16:creationId xmlns:a16="http://schemas.microsoft.com/office/drawing/2014/main" id="{91F15DE1-1BB2-FB5B-C586-06863DF4C1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12526" y="6325537"/>
                <a:ext cx="0" cy="40900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45" name="Line 183">
                <a:extLst>
                  <a:ext uri="{FF2B5EF4-FFF2-40B4-BE49-F238E27FC236}">
                    <a16:creationId xmlns:a16="http://schemas.microsoft.com/office/drawing/2014/main" id="{1FC08D63-4019-F0DB-C3C4-17B8A05077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72569" y="6325537"/>
                <a:ext cx="0" cy="40900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46" name="Line 185">
                <a:extLst>
                  <a:ext uri="{FF2B5EF4-FFF2-40B4-BE49-F238E27FC236}">
                    <a16:creationId xmlns:a16="http://schemas.microsoft.com/office/drawing/2014/main" id="{031A2860-35F8-1FAD-860F-88C17026CB7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28759" y="6325537"/>
                <a:ext cx="0" cy="40900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47" name="Line 187">
                <a:extLst>
                  <a:ext uri="{FF2B5EF4-FFF2-40B4-BE49-F238E27FC236}">
                    <a16:creationId xmlns:a16="http://schemas.microsoft.com/office/drawing/2014/main" id="{4DE2C86A-AA2D-303E-F039-4336BE73B2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86394" y="6325537"/>
                <a:ext cx="0" cy="40900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48" name="Line 189">
                <a:extLst>
                  <a:ext uri="{FF2B5EF4-FFF2-40B4-BE49-F238E27FC236}">
                    <a16:creationId xmlns:a16="http://schemas.microsoft.com/office/drawing/2014/main" id="{2E12EC44-4FB9-2A95-4EEC-60D3AF4BB8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45474" y="6323156"/>
                <a:ext cx="0" cy="40900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D854D46C-B324-E645-9A00-3DD40F344919}"/>
                  </a:ext>
                </a:extLst>
              </p:cNvPr>
              <p:cNvSpPr txBox="1"/>
              <p:nvPr/>
            </p:nvSpPr>
            <p:spPr>
              <a:xfrm>
                <a:off x="2264569" y="634523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/>
                  <a:t>13</a:t>
                </a:r>
                <a:endParaRPr lang="zh-CN" altLang="en-US" sz="800" b="1" dirty="0"/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54E3C9C0-867C-CF8B-F90E-6CE3BF99C86C}"/>
                  </a:ext>
                </a:extLst>
              </p:cNvPr>
              <p:cNvSpPr txBox="1"/>
              <p:nvPr/>
            </p:nvSpPr>
            <p:spPr>
              <a:xfrm>
                <a:off x="2721769" y="634523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/>
                  <a:t>14</a:t>
                </a:r>
                <a:endParaRPr lang="zh-CN" altLang="en-US" sz="800" b="1" dirty="0"/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8F0D921E-7CF0-DA2A-1ACC-076C86635B35}"/>
                  </a:ext>
                </a:extLst>
              </p:cNvPr>
              <p:cNvSpPr txBox="1"/>
              <p:nvPr/>
            </p:nvSpPr>
            <p:spPr>
              <a:xfrm>
                <a:off x="3181350" y="634523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/>
                  <a:t>15</a:t>
                </a:r>
                <a:endParaRPr lang="zh-CN" altLang="en-US" sz="800" b="1" dirty="0"/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A721400D-464B-0468-65F5-3F63BF6C29E3}"/>
                  </a:ext>
                </a:extLst>
              </p:cNvPr>
              <p:cNvSpPr txBox="1"/>
              <p:nvPr/>
            </p:nvSpPr>
            <p:spPr>
              <a:xfrm>
                <a:off x="3643312" y="634523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/>
                  <a:t>16</a:t>
                </a:r>
                <a:endParaRPr lang="zh-CN" altLang="en-US" sz="800" b="1" dirty="0"/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C5544E74-FCAA-0D08-FADC-1ACE77FE88DB}"/>
                  </a:ext>
                </a:extLst>
              </p:cNvPr>
              <p:cNvSpPr txBox="1"/>
              <p:nvPr/>
            </p:nvSpPr>
            <p:spPr>
              <a:xfrm>
                <a:off x="4095747" y="634523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/>
                  <a:t>17</a:t>
                </a:r>
                <a:endParaRPr lang="zh-CN" altLang="en-US" sz="800" b="1" dirty="0"/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E78948B5-1423-B601-2A1B-A7D47B154996}"/>
                  </a:ext>
                </a:extLst>
              </p:cNvPr>
              <p:cNvSpPr txBox="1"/>
              <p:nvPr/>
            </p:nvSpPr>
            <p:spPr>
              <a:xfrm>
                <a:off x="2574131" y="6530975"/>
                <a:ext cx="117692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tention time (min)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A050E0FB-1DF6-90C3-776D-9935DBE10343}"/>
                  </a:ext>
                </a:extLst>
              </p:cNvPr>
              <p:cNvSpPr txBox="1"/>
              <p:nvPr/>
            </p:nvSpPr>
            <p:spPr>
              <a:xfrm>
                <a:off x="1804988" y="6342062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/>
                  <a:t>12</a:t>
                </a:r>
                <a:endParaRPr lang="zh-CN" altLang="en-US" sz="800" b="1" dirty="0"/>
              </a:p>
            </p:txBody>
          </p:sp>
        </p:grp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AC8DB28B-B631-B3B3-CA28-B3453834AC04}"/>
                </a:ext>
              </a:extLst>
            </p:cNvPr>
            <p:cNvSpPr txBox="1"/>
            <p:nvPr/>
          </p:nvSpPr>
          <p:spPr>
            <a:xfrm>
              <a:off x="1741457" y="4434539"/>
              <a:ext cx="3337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/>
                <a:t>100</a:t>
              </a:r>
              <a:endParaRPr lang="zh-CN" altLang="en-US" sz="700" b="1" dirty="0"/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BACD6EC1-E93C-0C0D-C974-B77890CCC8A0}"/>
                </a:ext>
              </a:extLst>
            </p:cNvPr>
            <p:cNvSpPr txBox="1"/>
            <p:nvPr/>
          </p:nvSpPr>
          <p:spPr>
            <a:xfrm>
              <a:off x="1840843" y="4905234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/>
                <a:t>0</a:t>
              </a:r>
              <a:endParaRPr lang="zh-CN" altLang="en-US" sz="700" b="1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7C89D3CD-52FE-50BD-4CC7-3AD15C470FDF}"/>
              </a:ext>
            </a:extLst>
          </p:cNvPr>
          <p:cNvSpPr txBox="1"/>
          <p:nvPr/>
        </p:nvSpPr>
        <p:spPr>
          <a:xfrm>
            <a:off x="581015" y="5476902"/>
            <a:ext cx="574358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elative contents of enzymatic products of selected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P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using FPP as substrate.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old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F served as a negative control. The peak labels 1 to 5 represent (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-</a:t>
            </a:r>
            <a:r>
              <a:rPr lang="el-GR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rnesen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-</a:t>
            </a:r>
            <a:r>
              <a:rPr lang="el-GR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rnesen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l-GR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rnesen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-</a:t>
            </a:r>
            <a:r>
              <a:rPr lang="el-GR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-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sabolene, and (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-Farnesol, respectively. The highest peak was used as the reference scale (100%). The peaks of DTT across four chromatograms show similar peak heights.</a:t>
            </a:r>
          </a:p>
        </p:txBody>
      </p:sp>
    </p:spTree>
    <p:extLst>
      <p:ext uri="{BB962C8B-B14F-4D97-AF65-F5344CB8AC3E}">
        <p14:creationId xmlns:p14="http://schemas.microsoft.com/office/powerpoint/2010/main" val="7222218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BD4A3A93-BBAA-3849-CB0D-6BBACF2EDE1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0137283"/>
              </p:ext>
            </p:extLst>
          </p:nvPr>
        </p:nvGraphicFramePr>
        <p:xfrm>
          <a:off x="1017577" y="1417320"/>
          <a:ext cx="4822847" cy="28879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C615E4C5-CE6D-03B1-5841-6CB31165CE0F}"/>
              </a:ext>
            </a:extLst>
          </p:cNvPr>
          <p:cNvSpPr txBox="1"/>
          <p:nvPr/>
        </p:nvSpPr>
        <p:spPr>
          <a:xfrm>
            <a:off x="976181" y="4998317"/>
            <a:ext cx="49056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metabolite classes of 92 VOCs, significantly (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)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ociated with four MYB TF genes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15685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82</TotalTime>
  <Words>246</Words>
  <Application>Microsoft Office PowerPoint</Application>
  <PresentationFormat>A4 Paper (210x297 mm)</PresentationFormat>
  <Paragraphs>5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ao Song</dc:creator>
  <cp:lastModifiedBy>Chao Song</cp:lastModifiedBy>
  <cp:revision>1</cp:revision>
  <dcterms:created xsi:type="dcterms:W3CDTF">2024-07-17T02:03:14Z</dcterms:created>
  <dcterms:modified xsi:type="dcterms:W3CDTF">2024-11-22T03:03:48Z</dcterms:modified>
</cp:coreProperties>
</file>